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notesSlides/notesSlide3.xml" ContentType="application/vnd.openxmlformats-officedocument.presentationml.notesSl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drawings/drawing3.xml" ContentType="application/vnd.openxmlformats-officedocument.drawingml.chartshapes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drawings/drawing4.xml" ContentType="application/vnd.openxmlformats-officedocument.drawingml.chartshapes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drawings/drawing5.xml" ContentType="application/vnd.openxmlformats-officedocument.drawingml.chartshapes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drawings/drawing6.xml" ContentType="application/vnd.openxmlformats-officedocument.drawingml.chartshapes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drawings/drawing7.xml" ContentType="application/vnd.openxmlformats-officedocument.drawingml.chartshapes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2" r:id="rId2"/>
    <p:sldId id="267" r:id="rId3"/>
    <p:sldId id="1431" r:id="rId4"/>
    <p:sldId id="1423" r:id="rId5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47" userDrawn="1">
          <p15:clr>
            <a:srgbClr val="A4A3A4"/>
          </p15:clr>
        </p15:guide>
        <p15:guide id="3" pos="551" userDrawn="1">
          <p15:clr>
            <a:srgbClr val="A4A3A4"/>
          </p15:clr>
        </p15:guide>
        <p15:guide id="5" orient="horz" pos="4224" userDrawn="1">
          <p15:clr>
            <a:srgbClr val="A4A3A4"/>
          </p15:clr>
        </p15:guide>
        <p15:guide id="6" pos="5949" userDrawn="1">
          <p15:clr>
            <a:srgbClr val="A4A3A4"/>
          </p15:clr>
        </p15:guide>
        <p15:guide id="7" pos="7129" userDrawn="1">
          <p15:clr>
            <a:srgbClr val="A4A3A4"/>
          </p15:clr>
        </p15:guide>
        <p15:guide id="8" orient="horz" pos="459" userDrawn="1">
          <p15:clr>
            <a:srgbClr val="A4A3A4"/>
          </p15:clr>
        </p15:guide>
        <p15:guide id="9" orient="horz" pos="3997" userDrawn="1">
          <p15:clr>
            <a:srgbClr val="A4A3A4"/>
          </p15:clr>
        </p15:guide>
        <p15:guide id="10" orient="horz" pos="663" userDrawn="1">
          <p15:clr>
            <a:srgbClr val="A4A3A4"/>
          </p15:clr>
        </p15:guide>
        <p15:guide id="11" pos="1617" userDrawn="1">
          <p15:clr>
            <a:srgbClr val="A4A3A4"/>
          </p15:clr>
        </p15:guide>
        <p15:guide id="12" pos="3160" userDrawn="1">
          <p15:clr>
            <a:srgbClr val="A4A3A4"/>
          </p15:clr>
        </p15:guide>
        <p15:guide id="13" pos="470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中間スタイル 4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4995" autoAdjust="0"/>
    <p:restoredTop sz="82788" autoAdjust="0"/>
  </p:normalViewPr>
  <p:slideViewPr>
    <p:cSldViewPr snapToGrid="0" showGuides="1">
      <p:cViewPr varScale="1">
        <p:scale>
          <a:sx n="52" d="100"/>
          <a:sy n="52" d="100"/>
        </p:scale>
        <p:origin x="1228" y="52"/>
      </p:cViewPr>
      <p:guideLst>
        <p:guide orient="horz" pos="2047"/>
        <p:guide pos="551"/>
        <p:guide orient="horz" pos="4224"/>
        <p:guide pos="5949"/>
        <p:guide pos="7129"/>
        <p:guide orient="horz" pos="459"/>
        <p:guide orient="horz" pos="3997"/>
        <p:guide orient="horz" pos="663"/>
        <p:guide pos="1617"/>
        <p:guide pos="3160"/>
        <p:guide pos="470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esktop\&#21644;&#27468;&#23665;MIS-C1&#20363;&#30446;&#12288;20210909&#65293;10&#28204;&#23450;&#12288;&#12464;&#12521;&#12501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chartUserShapes" Target="../drawings/drawing3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chartUserShapes" Target="../drawings/drawing4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chartUserShapes" Target="../drawings/drawing5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chartUserShapes" Target="../drawings/drawing6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microsoft.com/office/2011/relationships/chartColorStyle" Target="colors15.xml"/><Relationship Id="rId1" Type="http://schemas.microsoft.com/office/2011/relationships/chartStyle" Target="style15.xml"/><Relationship Id="rId4" Type="http://schemas.openxmlformats.org/officeDocument/2006/relationships/chartUserShapes" Target="../drawings/drawing7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esktop\&#21644;&#27468;&#23665;MIS-C1&#20363;&#30446;&#12288;20210909&#65293;10&#28204;&#23450;&#12288;&#12464;&#12521;&#12501;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asuz\OneDrive\&#12487;&#12473;&#12463;&#12488;&#12483;&#12503;\MIS-C%20case%20report\&#37202;&#20117;&#20808;&#29983;&#12363;&#12425;&#12398;&#25991;&#29486;&#12539;&#12539;&#12487;&#12540;&#12479;\20220302&#21644;&#27468;&#23665;IFN&#955;&#65297;&#65286;&#65298;&#32080;&#26524;&#36865;&#20184;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esktop\&#21644;&#27468;&#23665;MIS-C1&#20363;&#30446;&#12288;20210909&#65293;10&#28204;&#23450;&#12288;&#12464;&#12521;&#12501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esktop\&#21644;&#27468;&#23665;MIS-C1&#20363;&#30446;&#12288;20210909&#65293;10&#28204;&#23450;&#12288;&#12464;&#12521;&#12501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400" b="1" i="0" u="none" strike="noStrike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CL23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4661898148148146"/>
          <c:y val="1.84187500000000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322321930458524"/>
          <c:y val="0.1812579861111111"/>
          <c:w val="0.74742453703703704"/>
          <c:h val="0.70168784722222211"/>
        </c:manualLayout>
      </c:layout>
      <c:lineChart>
        <c:grouping val="standard"/>
        <c:varyColors val="0"/>
        <c:ser>
          <c:idx val="0"/>
          <c:order val="0"/>
          <c:tx>
            <c:strRef>
              <c:f>'[1]グラフ(NCGMとの比較）'!$EK$3</c:f>
              <c:strCache>
                <c:ptCount val="1"/>
                <c:pt idx="0">
                  <c:v>Hu MPIF-1/CCL23 (37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[1]グラフ(NCGMとの比較）'!$EJ$4:$EJ$19</c:f>
              <c:numCache>
                <c:formatCode>General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'[1]グラフ(NCGMとの比較）'!$EK$4:$EK$19</c:f>
              <c:numCache>
                <c:formatCode>General</c:formatCode>
                <c:ptCount val="16"/>
                <c:pt idx="0">
                  <c:v>1184.53</c:v>
                </c:pt>
                <c:pt idx="1">
                  <c:v>1268.8599999999999</c:v>
                </c:pt>
                <c:pt idx="2">
                  <c:v>2288.11</c:v>
                </c:pt>
                <c:pt idx="3">
                  <c:v>3047.5</c:v>
                </c:pt>
                <c:pt idx="4">
                  <c:v>1417.39</c:v>
                </c:pt>
                <c:pt idx="5">
                  <c:v>2366.5300000000002</c:v>
                </c:pt>
                <c:pt idx="6">
                  <c:v>2407.94</c:v>
                </c:pt>
                <c:pt idx="7">
                  <c:v>1148.08</c:v>
                </c:pt>
                <c:pt idx="8">
                  <c:v>802.97</c:v>
                </c:pt>
                <c:pt idx="9">
                  <c:v>773.99</c:v>
                </c:pt>
                <c:pt idx="10">
                  <c:v>879.98</c:v>
                </c:pt>
                <c:pt idx="11">
                  <c:v>999.46</c:v>
                </c:pt>
                <c:pt idx="12">
                  <c:v>629.42999999999995</c:v>
                </c:pt>
                <c:pt idx="13">
                  <c:v>547.05999999999995</c:v>
                </c:pt>
                <c:pt idx="14">
                  <c:v>435.49</c:v>
                </c:pt>
                <c:pt idx="15">
                  <c:v>436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55E-4383-B653-868A67F3F6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5533120"/>
        <c:axId val="325553088"/>
      </c:lineChart>
      <c:catAx>
        <c:axId val="325533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25553088"/>
        <c:crosses val="autoZero"/>
        <c:auto val="1"/>
        <c:lblAlgn val="ctr"/>
        <c:lblOffset val="100"/>
        <c:noMultiLvlLbl val="0"/>
      </c:catAx>
      <c:valAx>
        <c:axId val="3255530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255331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L25</a:t>
            </a:r>
          </a:p>
        </c:rich>
      </c:tx>
      <c:layout>
        <c:manualLayout>
          <c:xMode val="edge"/>
          <c:yMode val="edge"/>
          <c:x val="0.3543027777777778"/>
          <c:y val="2.204861111111111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779625"/>
          <c:y val="0.18269479166666666"/>
          <c:w val="0.75568518518518524"/>
          <c:h val="0.6982649305555555"/>
        </c:manualLayout>
      </c:layout>
      <c:lineChart>
        <c:grouping val="standard"/>
        <c:varyColors val="0"/>
        <c:ser>
          <c:idx val="0"/>
          <c:order val="0"/>
          <c:tx>
            <c:strRef>
              <c:f>グラフ!$DO$3</c:f>
              <c:strCache>
                <c:ptCount val="1"/>
                <c:pt idx="0">
                  <c:v>Hu TECK/CCL25 (46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DN$4:$DN$19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DO$4:$DO$19</c:f>
              <c:numCache>
                <c:formatCode>General</c:formatCode>
                <c:ptCount val="16"/>
                <c:pt idx="0">
                  <c:v>1788.28</c:v>
                </c:pt>
                <c:pt idx="1">
                  <c:v>1938.23</c:v>
                </c:pt>
                <c:pt idx="2">
                  <c:v>2778.75</c:v>
                </c:pt>
                <c:pt idx="3">
                  <c:v>2848.12</c:v>
                </c:pt>
                <c:pt idx="4">
                  <c:v>2163.38</c:v>
                </c:pt>
                <c:pt idx="5">
                  <c:v>2244.7800000000002</c:v>
                </c:pt>
                <c:pt idx="6">
                  <c:v>2050.7600000000002</c:v>
                </c:pt>
                <c:pt idx="7">
                  <c:v>1410.39</c:v>
                </c:pt>
                <c:pt idx="8">
                  <c:v>993.88</c:v>
                </c:pt>
                <c:pt idx="9">
                  <c:v>1088.05</c:v>
                </c:pt>
                <c:pt idx="10">
                  <c:v>1382.26</c:v>
                </c:pt>
                <c:pt idx="11">
                  <c:v>1538.46</c:v>
                </c:pt>
                <c:pt idx="12">
                  <c:v>1541.58</c:v>
                </c:pt>
                <c:pt idx="13">
                  <c:v>1225.9000000000001</c:v>
                </c:pt>
                <c:pt idx="14">
                  <c:v>1188.33</c:v>
                </c:pt>
                <c:pt idx="15">
                  <c:v>1053.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E8E-4FC5-B580-8D6F196654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08548031"/>
        <c:axId val="2108546783"/>
      </c:lineChart>
      <c:catAx>
        <c:axId val="2108548031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108546783"/>
        <c:crosses val="autoZero"/>
        <c:auto val="1"/>
        <c:lblAlgn val="ctr"/>
        <c:lblOffset val="100"/>
        <c:noMultiLvlLbl val="0"/>
      </c:catAx>
      <c:valAx>
        <c:axId val="210854678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10854803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HGF</a:t>
            </a:r>
          </a:p>
        </c:rich>
      </c:tx>
      <c:layout>
        <c:manualLayout>
          <c:xMode val="edge"/>
          <c:yMode val="edge"/>
          <c:x val="0.38735555555555551"/>
          <c:y val="2.37840277777777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779625"/>
          <c:y val="0.18480000000000005"/>
          <c:w val="0.73988379629629641"/>
          <c:h val="0.68990381944444434"/>
        </c:manualLayout>
      </c:layout>
      <c:lineChart>
        <c:grouping val="standard"/>
        <c:varyColors val="0"/>
        <c:ser>
          <c:idx val="0"/>
          <c:order val="0"/>
          <c:tx>
            <c:strRef>
              <c:f>グラフ!$W$48</c:f>
              <c:strCache>
                <c:ptCount val="1"/>
                <c:pt idx="0">
                  <c:v>Hu HGF (62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V$49:$V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W$49:$W$64</c:f>
              <c:numCache>
                <c:formatCode>General</c:formatCode>
                <c:ptCount val="16"/>
                <c:pt idx="0">
                  <c:v>1685.85</c:v>
                </c:pt>
                <c:pt idx="1">
                  <c:v>1797.47</c:v>
                </c:pt>
                <c:pt idx="2">
                  <c:v>4457.66</c:v>
                </c:pt>
                <c:pt idx="3">
                  <c:v>2930.5</c:v>
                </c:pt>
                <c:pt idx="4">
                  <c:v>4662.7</c:v>
                </c:pt>
                <c:pt idx="5">
                  <c:v>4495.62</c:v>
                </c:pt>
                <c:pt idx="6">
                  <c:v>4589.84</c:v>
                </c:pt>
                <c:pt idx="7">
                  <c:v>970.22</c:v>
                </c:pt>
                <c:pt idx="8">
                  <c:v>864.13</c:v>
                </c:pt>
                <c:pt idx="9">
                  <c:v>759.75</c:v>
                </c:pt>
                <c:pt idx="10">
                  <c:v>628.01</c:v>
                </c:pt>
                <c:pt idx="11">
                  <c:v>525.54999999999995</c:v>
                </c:pt>
                <c:pt idx="12">
                  <c:v>365.29</c:v>
                </c:pt>
                <c:pt idx="13">
                  <c:v>361.48</c:v>
                </c:pt>
                <c:pt idx="14">
                  <c:v>302.8</c:v>
                </c:pt>
                <c:pt idx="15">
                  <c:v>223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C1D-48D2-ADE4-03D5E6D275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8037711"/>
        <c:axId val="408032303"/>
      </c:lineChart>
      <c:catAx>
        <c:axId val="408037711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08032303"/>
        <c:crosses val="autoZero"/>
        <c:auto val="1"/>
        <c:lblAlgn val="ctr"/>
        <c:lblOffset val="100"/>
        <c:noMultiLvlLbl val="0"/>
      </c:catAx>
      <c:valAx>
        <c:axId val="4080323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080377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NGF-β</a:t>
            </a:r>
          </a:p>
        </c:rich>
      </c:tx>
      <c:layout>
        <c:manualLayout>
          <c:xMode val="edge"/>
          <c:yMode val="edge"/>
          <c:x val="0.35775185185185188"/>
          <c:y val="2.690902777777777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1497175925925927"/>
          <c:y val="0.19005902777777778"/>
          <c:w val="0.70049675925925925"/>
          <c:h val="0.68649097222222233"/>
        </c:manualLayout>
      </c:layout>
      <c:lineChart>
        <c:grouping val="standard"/>
        <c:varyColors val="0"/>
        <c:ser>
          <c:idx val="0"/>
          <c:order val="0"/>
          <c:tx>
            <c:strRef>
              <c:f>グラフ!$EP$48</c:f>
              <c:strCache>
                <c:ptCount val="1"/>
                <c:pt idx="0">
                  <c:v>Hu b-NGF (46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EO$49:$EO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EP$49:$EP$64</c:f>
              <c:numCache>
                <c:formatCode>General</c:formatCode>
                <c:ptCount val="16"/>
                <c:pt idx="0">
                  <c:v>15.03</c:v>
                </c:pt>
                <c:pt idx="1">
                  <c:v>16.09</c:v>
                </c:pt>
                <c:pt idx="2">
                  <c:v>26.03</c:v>
                </c:pt>
                <c:pt idx="3">
                  <c:v>20.82</c:v>
                </c:pt>
                <c:pt idx="4">
                  <c:v>28.05</c:v>
                </c:pt>
                <c:pt idx="5">
                  <c:v>21.29</c:v>
                </c:pt>
                <c:pt idx="6">
                  <c:v>19.989999999999998</c:v>
                </c:pt>
                <c:pt idx="7">
                  <c:v>6.7</c:v>
                </c:pt>
                <c:pt idx="8">
                  <c:v>12.32</c:v>
                </c:pt>
                <c:pt idx="9">
                  <c:v>11.15</c:v>
                </c:pt>
                <c:pt idx="10">
                  <c:v>16.559999999999999</c:v>
                </c:pt>
                <c:pt idx="11">
                  <c:v>13.5</c:v>
                </c:pt>
                <c:pt idx="12">
                  <c:v>10.210000000000001</c:v>
                </c:pt>
                <c:pt idx="13">
                  <c:v>3.91</c:v>
                </c:pt>
                <c:pt idx="14">
                  <c:v>2.76</c:v>
                </c:pt>
                <c:pt idx="15">
                  <c:v>4.61000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E7C-4103-B3BD-CB1FBB5C7C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0933567"/>
        <c:axId val="340933983"/>
      </c:lineChart>
      <c:catAx>
        <c:axId val="340933567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40933983"/>
        <c:crosses val="autoZero"/>
        <c:auto val="1"/>
        <c:lblAlgn val="ctr"/>
        <c:lblOffset val="100"/>
        <c:noMultiLvlLbl val="0"/>
      </c:catAx>
      <c:valAx>
        <c:axId val="34093398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4093356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LIF</a:t>
            </a:r>
          </a:p>
        </c:rich>
      </c:tx>
      <c:layout>
        <c:manualLayout>
          <c:xMode val="edge"/>
          <c:yMode val="edge"/>
          <c:x val="0.40460972222222213"/>
          <c:y val="2.6458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6648333333333334"/>
          <c:y val="0.18564930555555556"/>
          <c:w val="0.75020416666666667"/>
          <c:h val="0.68649097222222233"/>
        </c:manualLayout>
      </c:layout>
      <c:lineChart>
        <c:grouping val="standard"/>
        <c:varyColors val="0"/>
        <c:ser>
          <c:idx val="0"/>
          <c:order val="0"/>
          <c:tx>
            <c:strRef>
              <c:f>グラフ!$CQ$48</c:f>
              <c:strCache>
                <c:ptCount val="1"/>
                <c:pt idx="0">
                  <c:v>Hu LIF (29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CP$49:$CP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CQ$49:$CQ$64</c:f>
              <c:numCache>
                <c:formatCode>General</c:formatCode>
                <c:ptCount val="16"/>
                <c:pt idx="0">
                  <c:v>178.32</c:v>
                </c:pt>
                <c:pt idx="1">
                  <c:v>159.6</c:v>
                </c:pt>
                <c:pt idx="2">
                  <c:v>293.57</c:v>
                </c:pt>
                <c:pt idx="3">
                  <c:v>251.07</c:v>
                </c:pt>
                <c:pt idx="4">
                  <c:v>232.07</c:v>
                </c:pt>
                <c:pt idx="5">
                  <c:v>254.81</c:v>
                </c:pt>
                <c:pt idx="6">
                  <c:v>282.87</c:v>
                </c:pt>
                <c:pt idx="7">
                  <c:v>201.79</c:v>
                </c:pt>
                <c:pt idx="8">
                  <c:v>140.05000000000001</c:v>
                </c:pt>
                <c:pt idx="9">
                  <c:v>124.31</c:v>
                </c:pt>
                <c:pt idx="10">
                  <c:v>140.05000000000001</c:v>
                </c:pt>
                <c:pt idx="11">
                  <c:v>107.82</c:v>
                </c:pt>
                <c:pt idx="12">
                  <c:v>104.41</c:v>
                </c:pt>
                <c:pt idx="13">
                  <c:v>124.31</c:v>
                </c:pt>
                <c:pt idx="14">
                  <c:v>73.5</c:v>
                </c:pt>
                <c:pt idx="1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287-4ACB-B73D-DB4A243F23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46197903"/>
        <c:axId val="646209967"/>
      </c:lineChart>
      <c:catAx>
        <c:axId val="646197903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6209967"/>
        <c:crosses val="autoZero"/>
        <c:auto val="1"/>
        <c:lblAlgn val="ctr"/>
        <c:lblOffset val="100"/>
        <c:noMultiLvlLbl val="0"/>
      </c:catAx>
      <c:valAx>
        <c:axId val="6462099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61979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SCF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6333981481481483"/>
          <c:y val="0.18809895833333334"/>
          <c:w val="0.75379444444444443"/>
          <c:h val="0.68682291666666673"/>
        </c:manualLayout>
      </c:layout>
      <c:lineChart>
        <c:grouping val="standard"/>
        <c:varyColors val="0"/>
        <c:ser>
          <c:idx val="0"/>
          <c:order val="0"/>
          <c:tx>
            <c:strRef>
              <c:f>グラフ!$DU$48</c:f>
              <c:strCache>
                <c:ptCount val="1"/>
                <c:pt idx="0">
                  <c:v>Hu SCF (65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DT$49:$DT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DU$49:$DU$64</c:f>
              <c:numCache>
                <c:formatCode>General</c:formatCode>
                <c:ptCount val="16"/>
                <c:pt idx="0">
                  <c:v>119.2</c:v>
                </c:pt>
                <c:pt idx="1">
                  <c:v>123.99</c:v>
                </c:pt>
                <c:pt idx="2">
                  <c:v>166.53</c:v>
                </c:pt>
                <c:pt idx="3">
                  <c:v>150.03</c:v>
                </c:pt>
                <c:pt idx="4">
                  <c:v>112.03</c:v>
                </c:pt>
                <c:pt idx="5">
                  <c:v>123.99</c:v>
                </c:pt>
                <c:pt idx="6">
                  <c:v>124.31</c:v>
                </c:pt>
                <c:pt idx="7">
                  <c:v>99.46</c:v>
                </c:pt>
                <c:pt idx="8">
                  <c:v>75.31</c:v>
                </c:pt>
                <c:pt idx="9">
                  <c:v>64.83</c:v>
                </c:pt>
                <c:pt idx="10">
                  <c:v>59.44</c:v>
                </c:pt>
                <c:pt idx="11">
                  <c:v>79.75</c:v>
                </c:pt>
                <c:pt idx="12">
                  <c:v>81.34</c:v>
                </c:pt>
                <c:pt idx="13">
                  <c:v>73.72</c:v>
                </c:pt>
                <c:pt idx="14">
                  <c:v>81.34</c:v>
                </c:pt>
                <c:pt idx="15">
                  <c:v>102.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9AF-4297-8472-B11EFE7ACF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4316479"/>
        <c:axId val="2094320639"/>
      </c:lineChart>
      <c:catAx>
        <c:axId val="2094316479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94320639"/>
        <c:crosses val="autoZero"/>
        <c:auto val="1"/>
        <c:lblAlgn val="ctr"/>
        <c:lblOffset val="100"/>
        <c:noMultiLvlLbl val="0"/>
      </c:catAx>
      <c:valAx>
        <c:axId val="20943206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943164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VEGF</a:t>
            </a:r>
          </a:p>
        </c:rich>
      </c:tx>
      <c:layout>
        <c:manualLayout>
          <c:xMode val="edge"/>
          <c:yMode val="edge"/>
          <c:x val="0.36803148148148146"/>
          <c:y val="2.6458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6648333333333334"/>
          <c:y val="0.18564930555555556"/>
          <c:w val="0.75126388888888884"/>
          <c:h val="0.69090069444444457"/>
        </c:manualLayout>
      </c:layout>
      <c:lineChart>
        <c:grouping val="standard"/>
        <c:varyColors val="0"/>
        <c:ser>
          <c:idx val="0"/>
          <c:order val="0"/>
          <c:tx>
            <c:strRef>
              <c:f>グラフ!$EM$48</c:f>
              <c:strCache>
                <c:ptCount val="1"/>
                <c:pt idx="0">
                  <c:v>Hu VEGF (45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EL$49:$EL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EM$49:$EM$64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86.14</c:v>
                </c:pt>
                <c:pt idx="4">
                  <c:v>172.32</c:v>
                </c:pt>
                <c:pt idx="5">
                  <c:v>225.63</c:v>
                </c:pt>
                <c:pt idx="6">
                  <c:v>335.5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14.01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9C2-46A6-8DEF-3C64FD2699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0917343"/>
        <c:axId val="340921503"/>
      </c:lineChart>
      <c:catAx>
        <c:axId val="340917343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40921503"/>
        <c:crosses val="autoZero"/>
        <c:auto val="1"/>
        <c:lblAlgn val="ctr"/>
        <c:lblOffset val="100"/>
        <c:noMultiLvlLbl val="0"/>
      </c:catAx>
      <c:valAx>
        <c:axId val="34092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40917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MIF</a:t>
            </a:r>
          </a:p>
        </c:rich>
      </c:tx>
      <c:layout>
        <c:manualLayout>
          <c:xMode val="edge"/>
          <c:yMode val="edge"/>
          <c:x val="0.39700416666666671"/>
          <c:y val="2.6458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0739027777777777"/>
          <c:y val="0.18460069444444444"/>
          <c:w val="0.70830324074074069"/>
          <c:h val="0.68632673611111106"/>
        </c:manualLayout>
      </c:layout>
      <c:lineChart>
        <c:grouping val="standard"/>
        <c:varyColors val="0"/>
        <c:ser>
          <c:idx val="0"/>
          <c:order val="0"/>
          <c:tx>
            <c:strRef>
              <c:f>グラフ!$CK$3</c:f>
              <c:strCache>
                <c:ptCount val="1"/>
                <c:pt idx="0">
                  <c:v>Hu MIF (35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CJ$4:$CJ$19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CK$4:$CK$19</c:f>
              <c:numCache>
                <c:formatCode>General</c:formatCode>
                <c:ptCount val="16"/>
                <c:pt idx="0">
                  <c:v>3617.37</c:v>
                </c:pt>
                <c:pt idx="1">
                  <c:v>3273.48</c:v>
                </c:pt>
                <c:pt idx="2">
                  <c:v>3220.08</c:v>
                </c:pt>
                <c:pt idx="3">
                  <c:v>3914.91</c:v>
                </c:pt>
                <c:pt idx="4">
                  <c:v>2634.55</c:v>
                </c:pt>
                <c:pt idx="5">
                  <c:v>5220.16</c:v>
                </c:pt>
                <c:pt idx="6">
                  <c:v>11282.94</c:v>
                </c:pt>
                <c:pt idx="7">
                  <c:v>2417.69</c:v>
                </c:pt>
                <c:pt idx="8">
                  <c:v>2210.91</c:v>
                </c:pt>
                <c:pt idx="9">
                  <c:v>1987.42</c:v>
                </c:pt>
                <c:pt idx="10">
                  <c:v>4468.8599999999997</c:v>
                </c:pt>
                <c:pt idx="11">
                  <c:v>3150.98</c:v>
                </c:pt>
                <c:pt idx="12">
                  <c:v>2708.1</c:v>
                </c:pt>
                <c:pt idx="13">
                  <c:v>2166.9299999999998</c:v>
                </c:pt>
                <c:pt idx="14">
                  <c:v>2113.69</c:v>
                </c:pt>
                <c:pt idx="15">
                  <c:v>2485.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951-458E-B80A-374EB6212C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70273247"/>
        <c:axId val="370278239"/>
      </c:lineChart>
      <c:catAx>
        <c:axId val="370273247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0278239"/>
        <c:crosses val="autoZero"/>
        <c:auto val="1"/>
        <c:lblAlgn val="ctr"/>
        <c:lblOffset val="100"/>
        <c:noMultiLvlLbl val="0"/>
      </c:catAx>
      <c:valAx>
        <c:axId val="3702782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02732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-CSF</a:t>
            </a:r>
          </a:p>
        </c:rich>
      </c:tx>
      <c:layout>
        <c:manualLayout>
          <c:xMode val="edge"/>
          <c:yMode val="edge"/>
          <c:x val="0.31193981481481481"/>
          <c:y val="2.6458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6617361111111112"/>
          <c:y val="0.19151423611111112"/>
          <c:w val="0.76159444444444457"/>
          <c:h val="0.68062604166666663"/>
        </c:manualLayout>
      </c:layout>
      <c:lineChart>
        <c:grouping val="standard"/>
        <c:varyColors val="0"/>
        <c:ser>
          <c:idx val="0"/>
          <c:order val="0"/>
          <c:tx>
            <c:strRef>
              <c:f>グラフ!$AF$3</c:f>
              <c:strCache>
                <c:ptCount val="1"/>
                <c:pt idx="0">
                  <c:v>Hu GM-CSF (34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AE$4:$AE$19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AF$4:$AF$19</c:f>
              <c:numCache>
                <c:formatCode>General</c:formatCode>
                <c:ptCount val="16"/>
                <c:pt idx="0">
                  <c:v>52.3</c:v>
                </c:pt>
                <c:pt idx="1">
                  <c:v>54.03</c:v>
                </c:pt>
                <c:pt idx="2">
                  <c:v>72.930000000000007</c:v>
                </c:pt>
                <c:pt idx="3">
                  <c:v>89.08</c:v>
                </c:pt>
                <c:pt idx="4">
                  <c:v>72.239999999999995</c:v>
                </c:pt>
                <c:pt idx="5">
                  <c:v>63.11</c:v>
                </c:pt>
                <c:pt idx="6">
                  <c:v>65.36</c:v>
                </c:pt>
                <c:pt idx="7">
                  <c:v>53.46</c:v>
                </c:pt>
                <c:pt idx="8">
                  <c:v>47.77</c:v>
                </c:pt>
                <c:pt idx="9">
                  <c:v>47.46</c:v>
                </c:pt>
                <c:pt idx="10">
                  <c:v>49.01</c:v>
                </c:pt>
                <c:pt idx="11">
                  <c:v>46.34</c:v>
                </c:pt>
                <c:pt idx="12">
                  <c:v>48.08</c:v>
                </c:pt>
                <c:pt idx="13">
                  <c:v>39.67</c:v>
                </c:pt>
                <c:pt idx="14">
                  <c:v>44.38</c:v>
                </c:pt>
                <c:pt idx="15">
                  <c:v>32.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ABF-4167-B342-18E3D2FD3E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68483391"/>
        <c:axId val="368496287"/>
      </c:lineChart>
      <c:catAx>
        <c:axId val="368483391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68496287"/>
        <c:crosses val="autoZero"/>
        <c:auto val="1"/>
        <c:lblAlgn val="ctr"/>
        <c:lblOffset val="100"/>
        <c:noMultiLvlLbl val="0"/>
      </c:catAx>
      <c:valAx>
        <c:axId val="36849628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684833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-α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0822758896072114"/>
          <c:y val="0.18740104166666671"/>
          <c:w val="0.85243330797082884"/>
          <c:h val="0.68815555555555552"/>
        </c:manualLayout>
      </c:layout>
      <c:lineChart>
        <c:grouping val="standard"/>
        <c:varyColors val="0"/>
        <c:ser>
          <c:idx val="0"/>
          <c:order val="0"/>
          <c:tx>
            <c:strRef>
              <c:f>グラフ!$DR$3</c:f>
              <c:strCache>
                <c:ptCount val="1"/>
                <c:pt idx="0">
                  <c:v>Hu TNF-a (36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DQ$4:$DQ$19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DR$4:$DR$19</c:f>
              <c:numCache>
                <c:formatCode>General</c:formatCode>
                <c:ptCount val="16"/>
                <c:pt idx="0">
                  <c:v>200.02</c:v>
                </c:pt>
                <c:pt idx="1">
                  <c:v>192.28</c:v>
                </c:pt>
                <c:pt idx="2">
                  <c:v>310.08</c:v>
                </c:pt>
                <c:pt idx="3">
                  <c:v>325.06</c:v>
                </c:pt>
                <c:pt idx="4">
                  <c:v>256.22000000000003</c:v>
                </c:pt>
                <c:pt idx="5">
                  <c:v>253.38</c:v>
                </c:pt>
                <c:pt idx="6">
                  <c:v>226.74</c:v>
                </c:pt>
                <c:pt idx="7">
                  <c:v>166.27</c:v>
                </c:pt>
                <c:pt idx="8">
                  <c:v>129.25</c:v>
                </c:pt>
                <c:pt idx="9">
                  <c:v>141.79</c:v>
                </c:pt>
                <c:pt idx="10">
                  <c:v>141.79</c:v>
                </c:pt>
                <c:pt idx="11">
                  <c:v>159.75</c:v>
                </c:pt>
                <c:pt idx="12">
                  <c:v>180.2</c:v>
                </c:pt>
                <c:pt idx="13">
                  <c:v>156.58000000000001</c:v>
                </c:pt>
                <c:pt idx="14">
                  <c:v>144.81</c:v>
                </c:pt>
                <c:pt idx="15">
                  <c:v>127.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A5F-4E29-B9C6-80C81003E2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7985311"/>
        <c:axId val="667981567"/>
      </c:lineChart>
      <c:catAx>
        <c:axId val="667985311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7981567"/>
        <c:crosses val="autoZero"/>
        <c:auto val="1"/>
        <c:lblAlgn val="ctr"/>
        <c:lblOffset val="100"/>
        <c:noMultiLvlLbl val="0"/>
      </c:catAx>
      <c:valAx>
        <c:axId val="6679815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79853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λ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0668472222222223"/>
          <c:y val="0.19151423611111112"/>
          <c:w val="0.71153796296296301"/>
          <c:h val="0.68507951388888877"/>
        </c:manualLayout>
      </c:layou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Sheet1!$C$2:$C$17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Sheet1!$D$2:$D$17</c:f>
              <c:numCache>
                <c:formatCode>0_);[Red]\(0\)</c:formatCode>
                <c:ptCount val="16"/>
                <c:pt idx="0">
                  <c:v>321.62070167064667</c:v>
                </c:pt>
                <c:pt idx="1">
                  <c:v>321.1890235543251</c:v>
                </c:pt>
                <c:pt idx="2">
                  <c:v>320.49067848920822</c:v>
                </c:pt>
                <c:pt idx="3">
                  <c:v>602.86879378557205</c:v>
                </c:pt>
                <c:pt idx="4">
                  <c:v>666.49392575025558</c:v>
                </c:pt>
                <c:pt idx="5">
                  <c:v>618.01727652549744</c:v>
                </c:pt>
                <c:pt idx="6">
                  <c:v>557.99112296104431</c:v>
                </c:pt>
                <c:pt idx="7">
                  <c:v>443.86085957288742</c:v>
                </c:pt>
                <c:pt idx="8">
                  <c:v>440.24694567918777</c:v>
                </c:pt>
                <c:pt idx="9">
                  <c:v>448.6096083521843</c:v>
                </c:pt>
                <c:pt idx="10">
                  <c:v>454.06773519515991</c:v>
                </c:pt>
                <c:pt idx="11">
                  <c:v>396.80633306503296</c:v>
                </c:pt>
                <c:pt idx="12">
                  <c:v>373.71850472688675</c:v>
                </c:pt>
                <c:pt idx="13">
                  <c:v>357.16026705503464</c:v>
                </c:pt>
                <c:pt idx="14">
                  <c:v>352.12061238288879</c:v>
                </c:pt>
                <c:pt idx="15" formatCode="0.0_);[Red]\(0.0\)">
                  <c:v>321.776062369346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F93-4864-845F-323A8CD01C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8121215"/>
        <c:axId val="848124959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>
                      <c:ext uri="{02D57815-91ED-43cb-92C2-25804820EDAC}">
                        <c15:formulaRef>
                          <c15:sqref>Sheet1!$C$2:$C$17</c15:sqref>
                        </c15:formulaRef>
                      </c:ext>
                    </c:extLst>
                    <c:numCache>
                      <c:formatCode>0_);[Red]\(0\)</c:formatCode>
                      <c:ptCount val="16"/>
                      <c:pt idx="0">
                        <c:v>2</c:v>
                      </c:pt>
                      <c:pt idx="1">
                        <c:v>3</c:v>
                      </c:pt>
                      <c:pt idx="2">
                        <c:v>4</c:v>
                      </c:pt>
                      <c:pt idx="3">
                        <c:v>5</c:v>
                      </c:pt>
                      <c:pt idx="4">
                        <c:v>6</c:v>
                      </c:pt>
                      <c:pt idx="5">
                        <c:v>7</c:v>
                      </c:pt>
                      <c:pt idx="6">
                        <c:v>8</c:v>
                      </c:pt>
                      <c:pt idx="7">
                        <c:v>10</c:v>
                      </c:pt>
                      <c:pt idx="8">
                        <c:v>12</c:v>
                      </c:pt>
                      <c:pt idx="9">
                        <c:v>13</c:v>
                      </c:pt>
                      <c:pt idx="10">
                        <c:v>16</c:v>
                      </c:pt>
                      <c:pt idx="11">
                        <c:v>19</c:v>
                      </c:pt>
                      <c:pt idx="12">
                        <c:v>23</c:v>
                      </c:pt>
                      <c:pt idx="13">
                        <c:v>26</c:v>
                      </c:pt>
                      <c:pt idx="14">
                        <c:v>34</c:v>
                      </c:pt>
                      <c:pt idx="15">
                        <c:v>166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1!$C$2:$C$17</c15:sqref>
                        </c15:formulaRef>
                      </c:ext>
                    </c:extLst>
                    <c:numCache>
                      <c:formatCode>0_);[Red]\(0\)</c:formatCode>
                      <c:ptCount val="16"/>
                      <c:pt idx="0">
                        <c:v>2</c:v>
                      </c:pt>
                      <c:pt idx="1">
                        <c:v>3</c:v>
                      </c:pt>
                      <c:pt idx="2">
                        <c:v>4</c:v>
                      </c:pt>
                      <c:pt idx="3">
                        <c:v>5</c:v>
                      </c:pt>
                      <c:pt idx="4">
                        <c:v>6</c:v>
                      </c:pt>
                      <c:pt idx="5">
                        <c:v>7</c:v>
                      </c:pt>
                      <c:pt idx="6">
                        <c:v>8</c:v>
                      </c:pt>
                      <c:pt idx="7">
                        <c:v>10</c:v>
                      </c:pt>
                      <c:pt idx="8">
                        <c:v>12</c:v>
                      </c:pt>
                      <c:pt idx="9">
                        <c:v>13</c:v>
                      </c:pt>
                      <c:pt idx="10">
                        <c:v>16</c:v>
                      </c:pt>
                      <c:pt idx="11">
                        <c:v>19</c:v>
                      </c:pt>
                      <c:pt idx="12">
                        <c:v>23</c:v>
                      </c:pt>
                      <c:pt idx="13">
                        <c:v>26</c:v>
                      </c:pt>
                      <c:pt idx="14">
                        <c:v>34</c:v>
                      </c:pt>
                      <c:pt idx="15">
                        <c:v>166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1-6F93-4864-845F-323A8CD01CC3}"/>
                  </c:ext>
                </c:extLst>
              </c15:ser>
            </c15:filteredLineSeries>
          </c:ext>
        </c:extLst>
      </c:lineChart>
      <c:catAx>
        <c:axId val="848121215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48124959"/>
        <c:crosses val="autoZero"/>
        <c:auto val="1"/>
        <c:lblAlgn val="ctr"/>
        <c:lblOffset val="100"/>
        <c:noMultiLvlLbl val="0"/>
      </c:catAx>
      <c:valAx>
        <c:axId val="848124959"/>
        <c:scaling>
          <c:orientation val="minMax"/>
          <c:max val="7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481212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400" b="1" i="0" u="none" strike="noStrike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X3CL1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3144907407407409"/>
          <c:y val="1.760694444444444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7793287037037034"/>
          <c:y val="0.18272430555555555"/>
          <c:w val="0.74620787037037029"/>
          <c:h val="0.69727812499999997"/>
        </c:manualLayout>
      </c:layout>
      <c:lineChart>
        <c:grouping val="standard"/>
        <c:varyColors val="0"/>
        <c:ser>
          <c:idx val="0"/>
          <c:order val="0"/>
          <c:tx>
            <c:strRef>
              <c:f>'[1]グラフ(NCGMとの比較）'!$AG$3</c:f>
              <c:strCache>
                <c:ptCount val="1"/>
                <c:pt idx="0">
                  <c:v>Hu Fractalkine/CX3CL1 (77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[1]グラフ(NCGMとの比較）'!$AF$4:$AF$19</c:f>
              <c:numCache>
                <c:formatCode>General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'[1]グラフ(NCGMとの比較）'!$AG$4:$AG$19</c:f>
              <c:numCache>
                <c:formatCode>General</c:formatCode>
                <c:ptCount val="16"/>
                <c:pt idx="0">
                  <c:v>265.08</c:v>
                </c:pt>
                <c:pt idx="1">
                  <c:v>261.24</c:v>
                </c:pt>
                <c:pt idx="2">
                  <c:v>332.82</c:v>
                </c:pt>
                <c:pt idx="3">
                  <c:v>426.99</c:v>
                </c:pt>
                <c:pt idx="4">
                  <c:v>354.52</c:v>
                </c:pt>
                <c:pt idx="5">
                  <c:v>566.58000000000004</c:v>
                </c:pt>
                <c:pt idx="6">
                  <c:v>661.88</c:v>
                </c:pt>
                <c:pt idx="7">
                  <c:v>376.19</c:v>
                </c:pt>
                <c:pt idx="8">
                  <c:v>222.28</c:v>
                </c:pt>
                <c:pt idx="9">
                  <c:v>231.28</c:v>
                </c:pt>
                <c:pt idx="10">
                  <c:v>177.99</c:v>
                </c:pt>
                <c:pt idx="11">
                  <c:v>164.69</c:v>
                </c:pt>
                <c:pt idx="12">
                  <c:v>163.80000000000001</c:v>
                </c:pt>
                <c:pt idx="13">
                  <c:v>150.01</c:v>
                </c:pt>
                <c:pt idx="14">
                  <c:v>249.33</c:v>
                </c:pt>
                <c:pt idx="15">
                  <c:v>149.36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6EA-47F7-B012-2CF5080375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5045040"/>
        <c:axId val="2085042544"/>
      </c:lineChart>
      <c:catAx>
        <c:axId val="2085045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85042544"/>
        <c:crosses val="autoZero"/>
        <c:auto val="1"/>
        <c:lblAlgn val="ctr"/>
        <c:lblOffset val="100"/>
        <c:noMultiLvlLbl val="0"/>
      </c:catAx>
      <c:valAx>
        <c:axId val="2085042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85045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400" b="1" i="0" u="none" strike="noStrike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XCL13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1808194444444443"/>
          <c:y val="1.92229166666666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5993518518518518"/>
          <c:y val="0.18139965277777775"/>
          <c:w val="0.75333379629629627"/>
          <c:h val="0.69871736111111105"/>
        </c:manualLayout>
      </c:layout>
      <c:lineChart>
        <c:grouping val="standard"/>
        <c:varyColors val="0"/>
        <c:ser>
          <c:idx val="0"/>
          <c:order val="0"/>
          <c:tx>
            <c:strRef>
              <c:f>'[1]グラフ(NCGMとの比較）'!$I$3</c:f>
              <c:strCache>
                <c:ptCount val="1"/>
                <c:pt idx="0">
                  <c:v>Hu BCA-1/CXCL13 (74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[1]グラフ(NCGMとの比較）'!$H$4:$H$19</c:f>
              <c:numCache>
                <c:formatCode>General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'[1]グラフ(NCGMとの比較）'!$I$4:$I$19</c:f>
              <c:numCache>
                <c:formatCode>General</c:formatCode>
                <c:ptCount val="16"/>
                <c:pt idx="0">
                  <c:v>93.67</c:v>
                </c:pt>
                <c:pt idx="1">
                  <c:v>87.65</c:v>
                </c:pt>
                <c:pt idx="2">
                  <c:v>199.37</c:v>
                </c:pt>
                <c:pt idx="3">
                  <c:v>379.61</c:v>
                </c:pt>
                <c:pt idx="4">
                  <c:v>668.17</c:v>
                </c:pt>
                <c:pt idx="5">
                  <c:v>531.84</c:v>
                </c:pt>
                <c:pt idx="6">
                  <c:v>587.28</c:v>
                </c:pt>
                <c:pt idx="7">
                  <c:v>90.04</c:v>
                </c:pt>
                <c:pt idx="8">
                  <c:v>52.31</c:v>
                </c:pt>
                <c:pt idx="9">
                  <c:v>47.67</c:v>
                </c:pt>
                <c:pt idx="10">
                  <c:v>61.01</c:v>
                </c:pt>
                <c:pt idx="11">
                  <c:v>46.82</c:v>
                </c:pt>
                <c:pt idx="12">
                  <c:v>42.63</c:v>
                </c:pt>
                <c:pt idx="13">
                  <c:v>43.57</c:v>
                </c:pt>
                <c:pt idx="14">
                  <c:v>59.46</c:v>
                </c:pt>
                <c:pt idx="15">
                  <c:v>50.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AA4-475C-AF9F-00F6DAF677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8655504"/>
        <c:axId val="2088672976"/>
      </c:lineChart>
      <c:catAx>
        <c:axId val="208865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88672976"/>
        <c:crosses val="autoZero"/>
        <c:auto val="1"/>
        <c:lblAlgn val="ctr"/>
        <c:lblOffset val="100"/>
        <c:noMultiLvlLbl val="0"/>
      </c:catAx>
      <c:valAx>
        <c:axId val="2088672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8865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400" b="1" i="0" u="none" strike="noStrike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FN-α2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6201064814814814"/>
          <c:y val="0.18324583333333333"/>
          <c:w val="0.74981944444444448"/>
          <c:h val="0.69905763888888905"/>
        </c:manualLayout>
      </c:layout>
      <c:lineChart>
        <c:grouping val="standard"/>
        <c:varyColors val="0"/>
        <c:ser>
          <c:idx val="1"/>
          <c:order val="0"/>
          <c:tx>
            <c:strRef>
              <c:f>グラフ!$AA$48</c:f>
              <c:strCache>
                <c:ptCount val="1"/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Y$49:$Y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AA$49:$AA$64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11.78</c:v>
                </c:pt>
                <c:pt idx="3">
                  <c:v>12.98</c:v>
                </c:pt>
                <c:pt idx="4">
                  <c:v>9.23</c:v>
                </c:pt>
                <c:pt idx="5">
                  <c:v>11.37</c:v>
                </c:pt>
                <c:pt idx="6">
                  <c:v>11.78</c:v>
                </c:pt>
                <c:pt idx="7">
                  <c:v>5.0599999999999996</c:v>
                </c:pt>
                <c:pt idx="8">
                  <c:v>3.6</c:v>
                </c:pt>
                <c:pt idx="9">
                  <c:v>0.4</c:v>
                </c:pt>
                <c:pt idx="10">
                  <c:v>2.95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A50-4FDA-B4A2-F5F9ACB1D1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36441120"/>
        <c:axId val="636450272"/>
      </c:lineChart>
      <c:catAx>
        <c:axId val="636441120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6450272"/>
        <c:crosses val="autoZero"/>
        <c:auto val="1"/>
        <c:lblAlgn val="ctr"/>
        <c:lblOffset val="100"/>
        <c:noMultiLvlLbl val="0"/>
      </c:catAx>
      <c:valAx>
        <c:axId val="636450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64411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IL-1α</a:t>
            </a:r>
          </a:p>
        </c:rich>
      </c:tx>
      <c:layout>
        <c:manualLayout>
          <c:xMode val="edge"/>
          <c:yMode val="edge"/>
          <c:x val="0.37372499999999997"/>
          <c:y val="2.86722222222222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7617175925925924"/>
          <c:y val="0.18564930555555556"/>
          <c:w val="0.75333472222222209"/>
          <c:h val="0.68649097222222233"/>
        </c:manualLayout>
      </c:layout>
      <c:lineChart>
        <c:grouping val="standard"/>
        <c:varyColors val="0"/>
        <c:ser>
          <c:idx val="0"/>
          <c:order val="0"/>
          <c:tx>
            <c:strRef>
              <c:f>グラフ!$BD$48</c:f>
              <c:strCache>
                <c:ptCount val="1"/>
                <c:pt idx="0">
                  <c:v>Hu IL-1a (63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BC$49:$BC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BD$49:$BD$64</c:f>
              <c:numCache>
                <c:formatCode>General</c:formatCode>
                <c:ptCount val="16"/>
                <c:pt idx="0">
                  <c:v>38.24</c:v>
                </c:pt>
                <c:pt idx="1">
                  <c:v>35.380000000000003</c:v>
                </c:pt>
                <c:pt idx="2">
                  <c:v>72.53</c:v>
                </c:pt>
                <c:pt idx="3">
                  <c:v>71.569999999999993</c:v>
                </c:pt>
                <c:pt idx="4">
                  <c:v>62.53</c:v>
                </c:pt>
                <c:pt idx="5">
                  <c:v>72.05</c:v>
                </c:pt>
                <c:pt idx="6">
                  <c:v>62.05</c:v>
                </c:pt>
                <c:pt idx="7">
                  <c:v>59.2</c:v>
                </c:pt>
                <c:pt idx="8">
                  <c:v>49.68</c:v>
                </c:pt>
                <c:pt idx="9">
                  <c:v>49.68</c:v>
                </c:pt>
                <c:pt idx="10">
                  <c:v>38.24</c:v>
                </c:pt>
                <c:pt idx="11">
                  <c:v>35.380000000000003</c:v>
                </c:pt>
                <c:pt idx="12">
                  <c:v>40.15</c:v>
                </c:pt>
                <c:pt idx="13">
                  <c:v>25.81</c:v>
                </c:pt>
                <c:pt idx="14">
                  <c:v>22.94</c:v>
                </c:pt>
                <c:pt idx="15">
                  <c:v>2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607-4F20-80E2-C5045944EE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70240799"/>
        <c:axId val="370237055"/>
      </c:lineChart>
      <c:catAx>
        <c:axId val="370240799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0237055"/>
        <c:crosses val="autoZero"/>
        <c:auto val="1"/>
        <c:lblAlgn val="ctr"/>
        <c:lblOffset val="100"/>
        <c:noMultiLvlLbl val="0"/>
      </c:catAx>
      <c:valAx>
        <c:axId val="37023705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02407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900"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IL-2Rα</a:t>
            </a:r>
          </a:p>
        </c:rich>
      </c:tx>
      <c:layout>
        <c:manualLayout>
          <c:xMode val="edge"/>
          <c:yMode val="edge"/>
          <c:x val="0.36235601851851851"/>
          <c:y val="2.82479166666666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7236296296296297"/>
          <c:y val="0.18564930555555556"/>
          <c:w val="0.7495194444444444"/>
          <c:h val="0.68649097222222233"/>
        </c:manualLayout>
      </c:layout>
      <c:lineChart>
        <c:grouping val="standard"/>
        <c:varyColors val="0"/>
        <c:ser>
          <c:idx val="0"/>
          <c:order val="0"/>
          <c:tx>
            <c:strRef>
              <c:f>グラフ!$BP$48</c:f>
              <c:strCache>
                <c:ptCount val="1"/>
                <c:pt idx="0">
                  <c:v>Hu IL-2Ra (13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BO$49:$BO$65</c:f>
              <c:numCache>
                <c:formatCode>0_);[Red]\(0\)</c:formatCode>
                <c:ptCount val="17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BP$49:$BP$65</c:f>
              <c:numCache>
                <c:formatCode>General</c:formatCode>
                <c:ptCount val="17"/>
                <c:pt idx="0">
                  <c:v>195.21</c:v>
                </c:pt>
                <c:pt idx="1">
                  <c:v>181.49</c:v>
                </c:pt>
                <c:pt idx="2">
                  <c:v>678.57</c:v>
                </c:pt>
                <c:pt idx="3">
                  <c:v>842.54</c:v>
                </c:pt>
                <c:pt idx="4">
                  <c:v>785.27</c:v>
                </c:pt>
                <c:pt idx="5">
                  <c:v>745.84</c:v>
                </c:pt>
                <c:pt idx="6">
                  <c:v>743.09</c:v>
                </c:pt>
                <c:pt idx="7">
                  <c:v>338.1</c:v>
                </c:pt>
                <c:pt idx="8">
                  <c:v>286.70999999999998</c:v>
                </c:pt>
                <c:pt idx="9">
                  <c:v>279.73</c:v>
                </c:pt>
                <c:pt idx="10">
                  <c:v>225.2</c:v>
                </c:pt>
                <c:pt idx="11">
                  <c:v>168.25</c:v>
                </c:pt>
                <c:pt idx="12">
                  <c:v>124.64</c:v>
                </c:pt>
                <c:pt idx="13">
                  <c:v>98.94</c:v>
                </c:pt>
                <c:pt idx="14">
                  <c:v>84.41</c:v>
                </c:pt>
                <c:pt idx="15">
                  <c:v>77.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EA2-41D2-92FF-A83086C4D4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46244495"/>
        <c:axId val="646254063"/>
      </c:lineChart>
      <c:catAx>
        <c:axId val="646244495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6254063"/>
        <c:crosses val="autoZero"/>
        <c:auto val="1"/>
        <c:lblAlgn val="ctr"/>
        <c:lblOffset val="100"/>
        <c:noMultiLvlLbl val="0"/>
      </c:catAx>
      <c:valAx>
        <c:axId val="646254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62444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IL-1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6569074074074075"/>
          <c:y val="0.18564930555555556"/>
          <c:w val="0.75205648148148152"/>
          <c:h val="0.68649097222222233"/>
        </c:manualLayout>
      </c:layout>
      <c:lineChart>
        <c:grouping val="standard"/>
        <c:varyColors val="0"/>
        <c:ser>
          <c:idx val="0"/>
          <c:order val="0"/>
          <c:tx>
            <c:strRef>
              <c:f>グラフ!$AO$48</c:f>
              <c:strCache>
                <c:ptCount val="1"/>
                <c:pt idx="0">
                  <c:v>Hu IL-13 (51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AN$49:$AN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AO$49:$AO$64</c:f>
              <c:numCache>
                <c:formatCode>General</c:formatCode>
                <c:ptCount val="16"/>
                <c:pt idx="0">
                  <c:v>1.73</c:v>
                </c:pt>
                <c:pt idx="1">
                  <c:v>1.58</c:v>
                </c:pt>
                <c:pt idx="2">
                  <c:v>3.32</c:v>
                </c:pt>
                <c:pt idx="3">
                  <c:v>3.07</c:v>
                </c:pt>
                <c:pt idx="4">
                  <c:v>2.5499999999999998</c:v>
                </c:pt>
                <c:pt idx="5">
                  <c:v>4.28</c:v>
                </c:pt>
                <c:pt idx="6">
                  <c:v>9.02</c:v>
                </c:pt>
                <c:pt idx="7">
                  <c:v>5.09</c:v>
                </c:pt>
                <c:pt idx="8">
                  <c:v>4.75</c:v>
                </c:pt>
                <c:pt idx="9">
                  <c:v>3.69</c:v>
                </c:pt>
                <c:pt idx="10">
                  <c:v>4.28</c:v>
                </c:pt>
                <c:pt idx="11">
                  <c:v>3.93</c:v>
                </c:pt>
                <c:pt idx="12">
                  <c:v>2.81</c:v>
                </c:pt>
                <c:pt idx="13">
                  <c:v>2.0099999999999998</c:v>
                </c:pt>
                <c:pt idx="14">
                  <c:v>2.0099999999999998</c:v>
                </c:pt>
                <c:pt idx="1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45E-441F-98CC-0E02DCDC35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6037071"/>
        <c:axId val="2046039151"/>
      </c:lineChart>
      <c:catAx>
        <c:axId val="2046037071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46039151"/>
        <c:crosses val="autoZero"/>
        <c:auto val="1"/>
        <c:lblAlgn val="ctr"/>
        <c:lblOffset val="100"/>
        <c:noMultiLvlLbl val="0"/>
      </c:catAx>
      <c:valAx>
        <c:axId val="204603915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460370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ra</a:t>
            </a:r>
          </a:p>
        </c:rich>
      </c:tx>
      <c:layout>
        <c:manualLayout>
          <c:xMode val="edge"/>
          <c:yMode val="edge"/>
          <c:x val="0.38339212962962971"/>
          <c:y val="2.6458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779625"/>
          <c:y val="0.18269479166666666"/>
          <c:w val="0.74392592592592588"/>
          <c:h val="0.68944548611111112"/>
        </c:manualLayout>
      </c:layout>
      <c:lineChart>
        <c:grouping val="standard"/>
        <c:varyColors val="0"/>
        <c:ser>
          <c:idx val="0"/>
          <c:order val="0"/>
          <c:tx>
            <c:strRef>
              <c:f>グラフ!$BJ$48</c:f>
              <c:strCache>
                <c:ptCount val="1"/>
                <c:pt idx="0">
                  <c:v>Hu IL-1ra (25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BI$49:$BI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BJ$49:$BJ$64</c:f>
              <c:numCache>
                <c:formatCode>General</c:formatCode>
                <c:ptCount val="16"/>
                <c:pt idx="0">
                  <c:v>1968.61</c:v>
                </c:pt>
                <c:pt idx="1">
                  <c:v>2055.2399999999998</c:v>
                </c:pt>
                <c:pt idx="2">
                  <c:v>6208.77</c:v>
                </c:pt>
                <c:pt idx="3">
                  <c:v>7580.06</c:v>
                </c:pt>
                <c:pt idx="4">
                  <c:v>2590.36</c:v>
                </c:pt>
                <c:pt idx="5">
                  <c:v>3491.96</c:v>
                </c:pt>
                <c:pt idx="6">
                  <c:v>4756.6400000000003</c:v>
                </c:pt>
                <c:pt idx="7">
                  <c:v>2531.23</c:v>
                </c:pt>
                <c:pt idx="8">
                  <c:v>1263.0899999999999</c:v>
                </c:pt>
                <c:pt idx="9">
                  <c:v>824.35</c:v>
                </c:pt>
                <c:pt idx="10">
                  <c:v>983.42</c:v>
                </c:pt>
                <c:pt idx="11">
                  <c:v>714.95</c:v>
                </c:pt>
                <c:pt idx="12">
                  <c:v>514.65</c:v>
                </c:pt>
                <c:pt idx="13">
                  <c:v>426.61</c:v>
                </c:pt>
                <c:pt idx="14">
                  <c:v>394.79</c:v>
                </c:pt>
                <c:pt idx="15">
                  <c:v>288.1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D5D-4E58-9E5B-CD88C75318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68493791"/>
        <c:axId val="368490463"/>
      </c:lineChart>
      <c:catAx>
        <c:axId val="368493791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68490463"/>
        <c:crosses val="autoZero"/>
        <c:auto val="1"/>
        <c:lblAlgn val="ctr"/>
        <c:lblOffset val="100"/>
        <c:noMultiLvlLbl val="0"/>
      </c:catAx>
      <c:valAx>
        <c:axId val="3684904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684937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IL-17</a:t>
            </a:r>
          </a:p>
        </c:rich>
      </c:tx>
      <c:layout>
        <c:manualLayout>
          <c:xMode val="edge"/>
          <c:yMode val="edge"/>
          <c:x val="0.38402407407407407"/>
          <c:y val="2.6458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6614398148148149"/>
          <c:y val="0.19151423611111112"/>
          <c:w val="0.76162407407407406"/>
          <c:h val="0.68503576388888887"/>
        </c:manualLayout>
      </c:layout>
      <c:lineChart>
        <c:grouping val="standard"/>
        <c:varyColors val="0"/>
        <c:ser>
          <c:idx val="0"/>
          <c:order val="0"/>
          <c:tx>
            <c:strRef>
              <c:f>グラフ!$AX$48</c:f>
              <c:strCache>
                <c:ptCount val="1"/>
                <c:pt idx="0">
                  <c:v>Hu IL-17 (76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グラフ!$AW$49:$AW$64</c:f>
              <c:numCache>
                <c:formatCode>0_);[Red]\(0\)</c:formatCode>
                <c:ptCount val="16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10</c:v>
                </c:pt>
                <c:pt idx="8">
                  <c:v>12</c:v>
                </c:pt>
                <c:pt idx="9">
                  <c:v>13</c:v>
                </c:pt>
                <c:pt idx="10">
                  <c:v>16</c:v>
                </c:pt>
                <c:pt idx="11">
                  <c:v>19</c:v>
                </c:pt>
                <c:pt idx="12">
                  <c:v>23</c:v>
                </c:pt>
                <c:pt idx="13">
                  <c:v>26</c:v>
                </c:pt>
                <c:pt idx="14">
                  <c:v>34</c:v>
                </c:pt>
                <c:pt idx="15">
                  <c:v>166</c:v>
                </c:pt>
              </c:numCache>
            </c:numRef>
          </c:cat>
          <c:val>
            <c:numRef>
              <c:f>グラフ!$AX$49:$AX$64</c:f>
              <c:numCache>
                <c:formatCode>General</c:formatCode>
                <c:ptCount val="16"/>
                <c:pt idx="0">
                  <c:v>0</c:v>
                </c:pt>
                <c:pt idx="1">
                  <c:v>10.46</c:v>
                </c:pt>
                <c:pt idx="2">
                  <c:v>31.92</c:v>
                </c:pt>
                <c:pt idx="3">
                  <c:v>34.049999999999997</c:v>
                </c:pt>
                <c:pt idx="4">
                  <c:v>30.91</c:v>
                </c:pt>
                <c:pt idx="5">
                  <c:v>29.11</c:v>
                </c:pt>
                <c:pt idx="6">
                  <c:v>22.83</c:v>
                </c:pt>
                <c:pt idx="7">
                  <c:v>13.73</c:v>
                </c:pt>
                <c:pt idx="8">
                  <c:v>13.17</c:v>
                </c:pt>
                <c:pt idx="9">
                  <c:v>10.0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9E0-44F9-9A6E-D1808B8DA8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70256191"/>
        <c:axId val="370243711"/>
      </c:lineChart>
      <c:catAx>
        <c:axId val="370256191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0243711"/>
        <c:crosses val="autoZero"/>
        <c:auto val="1"/>
        <c:lblAlgn val="ctr"/>
        <c:lblOffset val="100"/>
        <c:noMultiLvlLbl val="0"/>
      </c:catAx>
      <c:valAx>
        <c:axId val="37024371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02561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9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6442</cdr:x>
      <cdr:y>0.06219</cdr:y>
    </cdr:from>
    <cdr:to>
      <cdr:x>0.26267</cdr:x>
      <cdr:y>0.14234</cdr:y>
    </cdr:to>
    <cdr:sp macro="" textlink="">
      <cdr:nvSpPr>
        <cdr:cNvPr id="2" name="テキスト ボックス 37">
          <a:extLst xmlns:a="http://schemas.openxmlformats.org/drawingml/2006/main">
            <a:ext uri="{FF2B5EF4-FFF2-40B4-BE49-F238E27FC236}">
              <a16:creationId xmlns:a16="http://schemas.microsoft.com/office/drawing/2014/main" id="{211435F2-F849-4E0E-BC73-B5924B3E8062}"/>
            </a:ext>
          </a:extLst>
        </cdr:cNvPr>
        <cdr:cNvSpPr txBox="1"/>
      </cdr:nvSpPr>
      <cdr:spPr>
        <a:xfrm xmlns:a="http://schemas.openxmlformats.org/drawingml/2006/main">
          <a:off x="139151" y="179093"/>
          <a:ext cx="428220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g</a:t>
          </a:r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/mL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6194</cdr:x>
      <cdr:y>0.05875</cdr:y>
    </cdr:from>
    <cdr:to>
      <cdr:x>0.26019</cdr:x>
      <cdr:y>0.1389</cdr:y>
    </cdr:to>
    <cdr:sp macro="" textlink="">
      <cdr:nvSpPr>
        <cdr:cNvPr id="2" name="テキスト ボックス 37">
          <a:extLst xmlns:a="http://schemas.openxmlformats.org/drawingml/2006/main">
            <a:ext uri="{FF2B5EF4-FFF2-40B4-BE49-F238E27FC236}">
              <a16:creationId xmlns:a16="http://schemas.microsoft.com/office/drawing/2014/main" id="{211435F2-F849-4E0E-BC73-B5924B3E8062}"/>
            </a:ext>
          </a:extLst>
        </cdr:cNvPr>
        <cdr:cNvSpPr txBox="1"/>
      </cdr:nvSpPr>
      <cdr:spPr>
        <a:xfrm xmlns:a="http://schemas.openxmlformats.org/drawingml/2006/main">
          <a:off x="133787" y="169204"/>
          <a:ext cx="428220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g</a:t>
          </a:r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/mL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889</cdr:x>
      <cdr:y>0.1049</cdr:y>
    </cdr:from>
    <cdr:to>
      <cdr:x>0.28715</cdr:x>
      <cdr:y>0.18505</cdr:y>
    </cdr:to>
    <cdr:sp macro="" textlink="">
      <cdr:nvSpPr>
        <cdr:cNvPr id="2" name="テキスト ボックス 33">
          <a:extLst xmlns:a="http://schemas.openxmlformats.org/drawingml/2006/main">
            <a:ext uri="{FF2B5EF4-FFF2-40B4-BE49-F238E27FC236}">
              <a16:creationId xmlns:a16="http://schemas.microsoft.com/office/drawing/2014/main" id="{C4502DBF-764C-4789-B0DC-7C692CFE593D}"/>
            </a:ext>
          </a:extLst>
        </cdr:cNvPr>
        <cdr:cNvSpPr txBox="1"/>
      </cdr:nvSpPr>
      <cdr:spPr>
        <a:xfrm xmlns:a="http://schemas.openxmlformats.org/drawingml/2006/main">
          <a:off x="192024" y="302125"/>
          <a:ext cx="428220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g</a:t>
          </a:r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/mL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1876</cdr:x>
      <cdr:y>0.10568</cdr:y>
    </cdr:from>
    <cdr:to>
      <cdr:x>0.31701</cdr:x>
      <cdr:y>0.18583</cdr:y>
    </cdr:to>
    <cdr:sp macro="" textlink="">
      <cdr:nvSpPr>
        <cdr:cNvPr id="2" name="テキスト ボックス 33">
          <a:extLst xmlns:a="http://schemas.openxmlformats.org/drawingml/2006/main">
            <a:ext uri="{FF2B5EF4-FFF2-40B4-BE49-F238E27FC236}">
              <a16:creationId xmlns:a16="http://schemas.microsoft.com/office/drawing/2014/main" id="{C4502DBF-764C-4789-B0DC-7C692CFE593D}"/>
            </a:ext>
          </a:extLst>
        </cdr:cNvPr>
        <cdr:cNvSpPr txBox="1"/>
      </cdr:nvSpPr>
      <cdr:spPr>
        <a:xfrm xmlns:a="http://schemas.openxmlformats.org/drawingml/2006/main">
          <a:off x="256529" y="304354"/>
          <a:ext cx="428220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g</a:t>
          </a:r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/mL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07197</cdr:x>
      <cdr:y>0.1049</cdr:y>
    </cdr:from>
    <cdr:to>
      <cdr:x>0.27022</cdr:x>
      <cdr:y>0.18505</cdr:y>
    </cdr:to>
    <cdr:sp macro="" textlink="">
      <cdr:nvSpPr>
        <cdr:cNvPr id="2" name="テキスト ボックス 33">
          <a:extLst xmlns:a="http://schemas.openxmlformats.org/drawingml/2006/main">
            <a:ext uri="{FF2B5EF4-FFF2-40B4-BE49-F238E27FC236}">
              <a16:creationId xmlns:a16="http://schemas.microsoft.com/office/drawing/2014/main" id="{C4502DBF-764C-4789-B0DC-7C692CFE593D}"/>
            </a:ext>
          </a:extLst>
        </cdr:cNvPr>
        <cdr:cNvSpPr txBox="1"/>
      </cdr:nvSpPr>
      <cdr:spPr>
        <a:xfrm xmlns:a="http://schemas.openxmlformats.org/drawingml/2006/main">
          <a:off x="155448" y="302125"/>
          <a:ext cx="428220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g</a:t>
          </a:r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/mL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0762</cdr:x>
      <cdr:y>0.10568</cdr:y>
    </cdr:from>
    <cdr:to>
      <cdr:x>0.27445</cdr:x>
      <cdr:y>0.18583</cdr:y>
    </cdr:to>
    <cdr:sp macro="" textlink="">
      <cdr:nvSpPr>
        <cdr:cNvPr id="2" name="テキスト ボックス 33">
          <a:extLst xmlns:a="http://schemas.openxmlformats.org/drawingml/2006/main">
            <a:ext uri="{FF2B5EF4-FFF2-40B4-BE49-F238E27FC236}">
              <a16:creationId xmlns:a16="http://schemas.microsoft.com/office/drawing/2014/main" id="{7509DE74-7363-4EAF-A633-05FF91C86B49}"/>
            </a:ext>
          </a:extLst>
        </cdr:cNvPr>
        <cdr:cNvSpPr txBox="1"/>
      </cdr:nvSpPr>
      <cdr:spPr>
        <a:xfrm xmlns:a="http://schemas.openxmlformats.org/drawingml/2006/main">
          <a:off x="164592" y="304354"/>
          <a:ext cx="428220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g</a:t>
          </a:r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/mL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07657</cdr:x>
      <cdr:y>0.10568</cdr:y>
    </cdr:from>
    <cdr:to>
      <cdr:x>0.27482</cdr:x>
      <cdr:y>0.18583</cdr:y>
    </cdr:to>
    <cdr:sp macro="" textlink="">
      <cdr:nvSpPr>
        <cdr:cNvPr id="2" name="テキスト ボックス 33">
          <a:extLst xmlns:a="http://schemas.openxmlformats.org/drawingml/2006/main">
            <a:ext uri="{FF2B5EF4-FFF2-40B4-BE49-F238E27FC236}">
              <a16:creationId xmlns:a16="http://schemas.microsoft.com/office/drawing/2014/main" id="{42D60887-0D4A-4112-9E60-B1A87A31D30C}"/>
            </a:ext>
          </a:extLst>
        </cdr:cNvPr>
        <cdr:cNvSpPr txBox="1"/>
      </cdr:nvSpPr>
      <cdr:spPr>
        <a:xfrm xmlns:a="http://schemas.openxmlformats.org/drawingml/2006/main">
          <a:off x="165400" y="304354"/>
          <a:ext cx="428220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g</a:t>
          </a:r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/mL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5CAC38-4CB6-422A-8A5B-71B6F82F1E98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3434DA-11CB-4054-8C38-06530B609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98169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D70CC73-E507-4B2A-B100-24DC6DADB855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476524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3434DA-11CB-4054-8C38-06530B6096E3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0511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3434DA-11CB-4054-8C38-06530B6096E3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27589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E89890-80CE-413D-8F56-9CD3BFA585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EB45E4E-E269-433A-9DCE-B0162EDF15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0E8449-72BB-4946-AC60-4AFA46931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0F161F-CF41-452F-B85B-2F6CC98B7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E0FDFC-6C93-40DE-A567-37A7A83A9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540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6ECAD5-3E5A-4A3A-82AE-4ABF11CB2B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2268071-1091-4012-AD22-505331F270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9519BD-41FF-49A2-99D9-2444E1287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DE542D-E81B-48A7-AFB8-E7C49EA21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5D1CE7-C16C-4CA4-84E6-F30B11A4E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4411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CE60F6A-551E-435B-83BD-C069FB764C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FBFB56E-0C6B-48EB-8F9F-78133F1B68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727CC2-A71B-4FAA-A8BB-9F7D29A46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4478B6-AE7E-4F80-A6C8-38F8C655B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98079C-DB34-4943-8EDC-45EFB5FC4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7853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8F0411-4C15-4070-9DB3-27D9882829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35D216A-1325-4804-8526-9B3AAC1FA7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F7DB0A-DA8E-44F1-995D-312E889A5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5FDF99-3A9A-4FE5-994E-3CA365E91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09CD27-E64F-4BE3-8015-E3EF67B88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6473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D9C3BA-83BF-4035-A329-2C08278FB9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A860A92-5960-400F-B192-568D081BE2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0F644DB-B03C-4BF3-B5FD-B552527D8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5A265F-62B6-460F-AD6B-B4596268D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DD544ED-8EFF-41EC-9A1A-F307E43C6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0519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304A61-109A-4C55-A81F-91A5143F7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26599FB-505D-446F-84E0-511924EDD3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3F4EDB9-3BF1-44FF-AACF-B1F91E8D68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AB7708-C501-4983-9224-B3177C49B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4E6FF71-3E92-43A8-B9CF-623DB2202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2E6B5EB-89D8-4646-B19D-E0386D842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3246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F91917-67EA-4C04-A2E9-BA4502DE1B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8E341B0-B89B-47B1-9F59-FC9E608F58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30E8CD-F3CC-4A93-8275-73B150EDE2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9FECB8B-2008-4E2F-9D68-F016F00B49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1A9BC44-39EC-4B58-A40E-615709C6E0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1FC50F8-14FC-4B88-9502-2B91F03EC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F5E8390-547D-4805-B908-6D1AD3542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9C363BD-5316-40AD-BA84-B654B9189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394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F7335C-DA3B-46DF-99E3-3311DB48BC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73D4B66-0B81-4D8D-921F-FC0489BE5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1AC5192-E573-4A61-8A4E-1691B69D4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9611BDD-DF9B-4298-A512-EDF60270D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3248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20AD645-8E81-4857-B151-4CF6C9E86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736EB01-2A6E-4AF3-A9BD-D84246734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4CC4628-581B-492B-8C18-9EDEE3178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5473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FD7997-A611-4A87-9273-4866C7A80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18F5BDB-314F-46E8-9365-32379D4D2D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B735704-7C0B-4DC2-B61F-7A9887141D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2C89620-6BD7-4437-8278-0961839C1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DA18AAD-BB3E-47FD-AFAD-4DE3B5338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ACB6F45-9796-443A-97DC-08BAD69A5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7110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948009-D90E-4800-861D-0F7D6A091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D38BD62-0EB1-4742-A522-BC7B214E0B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E745552-BE04-4B06-A279-3F13325624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7C59955-9B6D-47E5-BB50-D1DF10F31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E42EF62-92DE-4A40-B87E-1FF57660B5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4B3102F-A165-4C3E-837E-586EA4C83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884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5A5EA2C-ADE2-4947-A803-430F3E349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5414DC-7C60-481E-BC19-FA9FE0DD45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360874-5813-4BDC-B4AB-B1E6B2590D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21015-215C-48E5-B667-82839FCB7A31}" type="datetimeFigureOut">
              <a:rPr kumimoji="1" lang="ja-JP" altLang="en-US" smtClean="0"/>
              <a:t>2022/3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75C2E21-C084-4B83-97B3-CBC2594AAE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DB5F81-8178-47FE-8262-2AFFB85C40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624CE5-AC47-41C0-8D7C-F44F9567D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901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6.xml"/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4.xml"/><Relationship Id="rId11" Type="http://schemas.openxmlformats.org/officeDocument/2006/relationships/chart" Target="../charts/chart19.xml"/><Relationship Id="rId5" Type="http://schemas.openxmlformats.org/officeDocument/2006/relationships/chart" Target="../charts/chart13.xml"/><Relationship Id="rId10" Type="http://schemas.openxmlformats.org/officeDocument/2006/relationships/chart" Target="../charts/chart18.xml"/><Relationship Id="rId4" Type="http://schemas.openxmlformats.org/officeDocument/2006/relationships/chart" Target="../charts/chart12.xml"/><Relationship Id="rId9" Type="http://schemas.openxmlformats.org/officeDocument/2006/relationships/chart" Target="../charts/char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>
            <a:extLst>
              <a:ext uri="{FF2B5EF4-FFF2-40B4-BE49-F238E27FC236}">
                <a16:creationId xmlns:a16="http://schemas.microsoft.com/office/drawing/2014/main" id="{DDA7FCB6-C2B5-47BC-AEBC-4EB293C22DD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12" t="9777" r="14724" b="26207"/>
          <a:stretch/>
        </p:blipFill>
        <p:spPr bwMode="auto">
          <a:xfrm>
            <a:off x="4502059" y="3691016"/>
            <a:ext cx="3354371" cy="2458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D13A4DB-EEEA-4501-A655-309D23A6EDE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14" t="5247" r="20215"/>
          <a:stretch/>
        </p:blipFill>
        <p:spPr bwMode="auto">
          <a:xfrm>
            <a:off x="464703" y="1266598"/>
            <a:ext cx="3639858" cy="48828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F58E52BB-AB59-4D1E-8AFA-8928C9211AF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12" t="9763" r="14724" b="26220"/>
          <a:stretch/>
        </p:blipFill>
        <p:spPr bwMode="auto">
          <a:xfrm>
            <a:off x="4502058" y="1266599"/>
            <a:ext cx="3354372" cy="2458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2">
            <a:extLst>
              <a:ext uri="{FF2B5EF4-FFF2-40B4-BE49-F238E27FC236}">
                <a16:creationId xmlns:a16="http://schemas.microsoft.com/office/drawing/2014/main" id="{AC4E99F5-2EDE-41CD-A0F3-A84D2E50B69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6441"/>
          <a:stretch/>
        </p:blipFill>
        <p:spPr bwMode="auto">
          <a:xfrm>
            <a:off x="8127137" y="1266599"/>
            <a:ext cx="2038860" cy="44534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2">
            <a:extLst>
              <a:ext uri="{FF2B5EF4-FFF2-40B4-BE49-F238E27FC236}">
                <a16:creationId xmlns:a16="http://schemas.microsoft.com/office/drawing/2014/main" id="{9202A3D7-CA89-4F2F-916A-2A1652BAEB9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21" r="27489"/>
          <a:stretch/>
        </p:blipFill>
        <p:spPr bwMode="auto">
          <a:xfrm>
            <a:off x="10165997" y="1266599"/>
            <a:ext cx="1773268" cy="44534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楕円 1">
            <a:extLst>
              <a:ext uri="{FF2B5EF4-FFF2-40B4-BE49-F238E27FC236}">
                <a16:creationId xmlns:a16="http://schemas.microsoft.com/office/drawing/2014/main" id="{C70D4DA6-323D-41A3-8C2F-DB06033F9B1D}"/>
              </a:ext>
            </a:extLst>
          </p:cNvPr>
          <p:cNvSpPr/>
          <p:nvPr/>
        </p:nvSpPr>
        <p:spPr>
          <a:xfrm rot="1705776">
            <a:off x="4655369" y="4918879"/>
            <a:ext cx="1292926" cy="504807"/>
          </a:xfrm>
          <a:prstGeom prst="ellipse">
            <a:avLst/>
          </a:prstGeom>
          <a:noFill/>
          <a:ln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楕円 11">
            <a:extLst>
              <a:ext uri="{FF2B5EF4-FFF2-40B4-BE49-F238E27FC236}">
                <a16:creationId xmlns:a16="http://schemas.microsoft.com/office/drawing/2014/main" id="{B412A039-5A44-4E56-9F4F-6EDB055938F6}"/>
              </a:ext>
            </a:extLst>
          </p:cNvPr>
          <p:cNvSpPr/>
          <p:nvPr/>
        </p:nvSpPr>
        <p:spPr>
          <a:xfrm rot="1059076">
            <a:off x="4644765" y="2731289"/>
            <a:ext cx="1171544" cy="462223"/>
          </a:xfrm>
          <a:prstGeom prst="ellipse">
            <a:avLst/>
          </a:prstGeom>
          <a:noFill/>
          <a:ln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5EC3B3D-F4C8-438C-A2D8-1CF96390FCF2}"/>
              </a:ext>
            </a:extLst>
          </p:cNvPr>
          <p:cNvSpPr txBox="1"/>
          <p:nvPr/>
        </p:nvSpPr>
        <p:spPr>
          <a:xfrm>
            <a:off x="110524" y="217407"/>
            <a:ext cx="35021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-Figure 1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3D32423-CC3C-42BC-8BAF-96B793CA9314}"/>
              </a:ext>
            </a:extLst>
          </p:cNvPr>
          <p:cNvSpPr txBox="1"/>
          <p:nvPr/>
        </p:nvSpPr>
        <p:spPr>
          <a:xfrm>
            <a:off x="464702" y="874914"/>
            <a:ext cx="5552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56E7D05-019D-4734-999A-FA06E91D1DF0}"/>
              </a:ext>
            </a:extLst>
          </p:cNvPr>
          <p:cNvSpPr txBox="1"/>
          <p:nvPr/>
        </p:nvSpPr>
        <p:spPr>
          <a:xfrm>
            <a:off x="4502057" y="843361"/>
            <a:ext cx="5552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A162A33-DD87-43BB-B275-84EA2D9A8130}"/>
              </a:ext>
            </a:extLst>
          </p:cNvPr>
          <p:cNvSpPr txBox="1"/>
          <p:nvPr/>
        </p:nvSpPr>
        <p:spPr>
          <a:xfrm>
            <a:off x="8187786" y="843360"/>
            <a:ext cx="5552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7316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B5671972-5A93-407B-B158-BB190F5DD97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94" t="8950" r="10227"/>
          <a:stretch/>
        </p:blipFill>
        <p:spPr bwMode="auto">
          <a:xfrm>
            <a:off x="2799079" y="680720"/>
            <a:ext cx="6593841" cy="60334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1361E57-B6E6-436F-8D79-109D69AAEF39}"/>
              </a:ext>
            </a:extLst>
          </p:cNvPr>
          <p:cNvSpPr txBox="1"/>
          <p:nvPr/>
        </p:nvSpPr>
        <p:spPr>
          <a:xfrm>
            <a:off x="208778" y="-27800"/>
            <a:ext cx="34026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-Figure 2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95465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C39EC8AB-E444-44D2-96A5-3F64A2EFFCA0}"/>
              </a:ext>
            </a:extLst>
          </p:cNvPr>
          <p:cNvSpPr/>
          <p:nvPr/>
        </p:nvSpPr>
        <p:spPr>
          <a:xfrm>
            <a:off x="3233847" y="4338260"/>
            <a:ext cx="108000" cy="2016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CE7F6033-7AD8-4F93-A042-F1A2439ED766}"/>
              </a:ext>
            </a:extLst>
          </p:cNvPr>
          <p:cNvSpPr/>
          <p:nvPr/>
        </p:nvSpPr>
        <p:spPr>
          <a:xfrm>
            <a:off x="3340133" y="4338260"/>
            <a:ext cx="306000" cy="2016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D4216C8F-18D9-4B90-A021-2BB7C716A4A2}"/>
              </a:ext>
            </a:extLst>
          </p:cNvPr>
          <p:cNvSpPr/>
          <p:nvPr/>
        </p:nvSpPr>
        <p:spPr>
          <a:xfrm>
            <a:off x="3643670" y="4338260"/>
            <a:ext cx="306000" cy="2016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59DE8B67-A43D-43A4-8F7F-5B2E626BA9BC}"/>
              </a:ext>
            </a:extLst>
          </p:cNvPr>
          <p:cNvSpPr/>
          <p:nvPr/>
        </p:nvSpPr>
        <p:spPr>
          <a:xfrm>
            <a:off x="746715" y="4332284"/>
            <a:ext cx="108000" cy="2016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640365FE-43A2-4900-8B02-5FF42DA0F552}"/>
              </a:ext>
            </a:extLst>
          </p:cNvPr>
          <p:cNvSpPr/>
          <p:nvPr/>
        </p:nvSpPr>
        <p:spPr>
          <a:xfrm>
            <a:off x="856550" y="4332284"/>
            <a:ext cx="306000" cy="2016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0E935FBA-B420-45E3-97A8-F245D39E487D}"/>
              </a:ext>
            </a:extLst>
          </p:cNvPr>
          <p:cNvSpPr/>
          <p:nvPr/>
        </p:nvSpPr>
        <p:spPr>
          <a:xfrm>
            <a:off x="1160087" y="4332284"/>
            <a:ext cx="306000" cy="2016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正方形/長方形 89">
            <a:extLst>
              <a:ext uri="{FF2B5EF4-FFF2-40B4-BE49-F238E27FC236}">
                <a16:creationId xmlns:a16="http://schemas.microsoft.com/office/drawing/2014/main" id="{7659B6CE-5440-4316-B0E5-6A1C3591C7A7}"/>
              </a:ext>
            </a:extLst>
          </p:cNvPr>
          <p:cNvSpPr/>
          <p:nvPr/>
        </p:nvSpPr>
        <p:spPr>
          <a:xfrm>
            <a:off x="5630238" y="4338260"/>
            <a:ext cx="108000" cy="1998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正方形/長方形 90">
            <a:extLst>
              <a:ext uri="{FF2B5EF4-FFF2-40B4-BE49-F238E27FC236}">
                <a16:creationId xmlns:a16="http://schemas.microsoft.com/office/drawing/2014/main" id="{EB8325C9-EFCF-4F9F-9FB6-0FBE92609A62}"/>
              </a:ext>
            </a:extLst>
          </p:cNvPr>
          <p:cNvSpPr/>
          <p:nvPr/>
        </p:nvSpPr>
        <p:spPr>
          <a:xfrm>
            <a:off x="5736524" y="4338260"/>
            <a:ext cx="306000" cy="1998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8464AABE-9708-492D-8E95-CD43433F7B07}"/>
              </a:ext>
            </a:extLst>
          </p:cNvPr>
          <p:cNvSpPr/>
          <p:nvPr/>
        </p:nvSpPr>
        <p:spPr>
          <a:xfrm>
            <a:off x="6040061" y="4338260"/>
            <a:ext cx="306000" cy="1998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A8690905-B142-4D25-87E6-507097671078}"/>
              </a:ext>
            </a:extLst>
          </p:cNvPr>
          <p:cNvSpPr/>
          <p:nvPr/>
        </p:nvSpPr>
        <p:spPr>
          <a:xfrm>
            <a:off x="8071433" y="4330886"/>
            <a:ext cx="108000" cy="2016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A5E4C87A-2CC3-41AB-B785-9976F0D0A0B2}"/>
              </a:ext>
            </a:extLst>
          </p:cNvPr>
          <p:cNvSpPr/>
          <p:nvPr/>
        </p:nvSpPr>
        <p:spPr>
          <a:xfrm>
            <a:off x="8177719" y="4330886"/>
            <a:ext cx="306000" cy="2016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844162D3-E470-4A9D-81ED-C35F22D5BCED}"/>
              </a:ext>
            </a:extLst>
          </p:cNvPr>
          <p:cNvSpPr/>
          <p:nvPr/>
        </p:nvSpPr>
        <p:spPr>
          <a:xfrm>
            <a:off x="8483407" y="4330886"/>
            <a:ext cx="306000" cy="2016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059BF745-35BA-412E-8976-90B22D2D3B81}"/>
              </a:ext>
            </a:extLst>
          </p:cNvPr>
          <p:cNvSpPr/>
          <p:nvPr/>
        </p:nvSpPr>
        <p:spPr>
          <a:xfrm>
            <a:off x="10514746" y="4324445"/>
            <a:ext cx="126000" cy="2016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正方形/長方形 96">
            <a:extLst>
              <a:ext uri="{FF2B5EF4-FFF2-40B4-BE49-F238E27FC236}">
                <a16:creationId xmlns:a16="http://schemas.microsoft.com/office/drawing/2014/main" id="{E7131D66-9DBB-4D1D-BA01-183AE85DCC86}"/>
              </a:ext>
            </a:extLst>
          </p:cNvPr>
          <p:cNvSpPr/>
          <p:nvPr/>
        </p:nvSpPr>
        <p:spPr>
          <a:xfrm>
            <a:off x="10630557" y="4324445"/>
            <a:ext cx="306000" cy="2016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CA65C124-957C-416B-A394-571543DB16BE}"/>
              </a:ext>
            </a:extLst>
          </p:cNvPr>
          <p:cNvSpPr/>
          <p:nvPr/>
        </p:nvSpPr>
        <p:spPr>
          <a:xfrm>
            <a:off x="10934094" y="4324445"/>
            <a:ext cx="306000" cy="2016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3E454660-0073-4262-B9E9-A128716B3E8D}"/>
              </a:ext>
            </a:extLst>
          </p:cNvPr>
          <p:cNvSpPr/>
          <p:nvPr/>
        </p:nvSpPr>
        <p:spPr>
          <a:xfrm>
            <a:off x="755499" y="1272784"/>
            <a:ext cx="126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C20E7614-3BD0-415A-9214-E180CA1E3755}"/>
              </a:ext>
            </a:extLst>
          </p:cNvPr>
          <p:cNvSpPr/>
          <p:nvPr/>
        </p:nvSpPr>
        <p:spPr>
          <a:xfrm>
            <a:off x="871310" y="1272784"/>
            <a:ext cx="2880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CCBB4A44-36C0-4FE3-8AD6-181239341B66}"/>
              </a:ext>
            </a:extLst>
          </p:cNvPr>
          <p:cNvSpPr/>
          <p:nvPr/>
        </p:nvSpPr>
        <p:spPr>
          <a:xfrm>
            <a:off x="1158965" y="1272784"/>
            <a:ext cx="324000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78C81C36-04FD-4730-BE8B-E971A5BE18C5}"/>
              </a:ext>
            </a:extLst>
          </p:cNvPr>
          <p:cNvSpPr/>
          <p:nvPr/>
        </p:nvSpPr>
        <p:spPr>
          <a:xfrm>
            <a:off x="3233847" y="1264626"/>
            <a:ext cx="108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2E2717A6-5FEB-4A18-BAE6-948F1FC052D3}"/>
              </a:ext>
            </a:extLst>
          </p:cNvPr>
          <p:cNvSpPr/>
          <p:nvPr/>
        </p:nvSpPr>
        <p:spPr>
          <a:xfrm>
            <a:off x="3340133" y="1264626"/>
            <a:ext cx="2880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067FECC2-A2AF-4D92-B482-398E57B2FA99}"/>
              </a:ext>
            </a:extLst>
          </p:cNvPr>
          <p:cNvSpPr/>
          <p:nvPr/>
        </p:nvSpPr>
        <p:spPr>
          <a:xfrm>
            <a:off x="3624620" y="1264626"/>
            <a:ext cx="324000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68D69E63-2E75-4263-A505-568F9F77F466}"/>
              </a:ext>
            </a:extLst>
          </p:cNvPr>
          <p:cNvSpPr/>
          <p:nvPr/>
        </p:nvSpPr>
        <p:spPr>
          <a:xfrm>
            <a:off x="5611188" y="1264626"/>
            <a:ext cx="108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7F000309-BAE0-4C84-BA93-7786EA9347A0}"/>
              </a:ext>
            </a:extLst>
          </p:cNvPr>
          <p:cNvSpPr/>
          <p:nvPr/>
        </p:nvSpPr>
        <p:spPr>
          <a:xfrm>
            <a:off x="5717474" y="1264626"/>
            <a:ext cx="2880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91D40329-8721-48EA-8447-9CB9CF1C9C1F}"/>
              </a:ext>
            </a:extLst>
          </p:cNvPr>
          <p:cNvSpPr/>
          <p:nvPr/>
        </p:nvSpPr>
        <p:spPr>
          <a:xfrm>
            <a:off x="6001961" y="1264626"/>
            <a:ext cx="284539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64DEC8E2-6E8C-436D-9872-9ECBA708AD75}"/>
              </a:ext>
            </a:extLst>
          </p:cNvPr>
          <p:cNvSpPr/>
          <p:nvPr/>
        </p:nvSpPr>
        <p:spPr>
          <a:xfrm>
            <a:off x="8071433" y="1274151"/>
            <a:ext cx="108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088009A6-5C7B-4437-B74B-4CAE476762A6}"/>
              </a:ext>
            </a:extLst>
          </p:cNvPr>
          <p:cNvSpPr/>
          <p:nvPr/>
        </p:nvSpPr>
        <p:spPr>
          <a:xfrm>
            <a:off x="8177719" y="1274151"/>
            <a:ext cx="2880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正方形/長方形 74">
            <a:extLst>
              <a:ext uri="{FF2B5EF4-FFF2-40B4-BE49-F238E27FC236}">
                <a16:creationId xmlns:a16="http://schemas.microsoft.com/office/drawing/2014/main" id="{EA0C8AD9-6AD9-4370-A54D-8E74B5A59493}"/>
              </a:ext>
            </a:extLst>
          </p:cNvPr>
          <p:cNvSpPr/>
          <p:nvPr/>
        </p:nvSpPr>
        <p:spPr>
          <a:xfrm>
            <a:off x="8471731" y="1274151"/>
            <a:ext cx="324000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D5BBB2DE-B6FB-4A30-A8A5-18C26790C214}"/>
              </a:ext>
            </a:extLst>
          </p:cNvPr>
          <p:cNvSpPr/>
          <p:nvPr/>
        </p:nvSpPr>
        <p:spPr>
          <a:xfrm>
            <a:off x="10534846" y="1274151"/>
            <a:ext cx="108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1959C374-C28D-48D5-B78C-EC4269532A17}"/>
              </a:ext>
            </a:extLst>
          </p:cNvPr>
          <p:cNvSpPr/>
          <p:nvPr/>
        </p:nvSpPr>
        <p:spPr>
          <a:xfrm>
            <a:off x="10641132" y="1274151"/>
            <a:ext cx="2880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71AE05D8-3FFF-4D57-88CC-D6314E2A56D1}"/>
              </a:ext>
            </a:extLst>
          </p:cNvPr>
          <p:cNvSpPr/>
          <p:nvPr/>
        </p:nvSpPr>
        <p:spPr>
          <a:xfrm>
            <a:off x="10925619" y="1274151"/>
            <a:ext cx="324000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0F1C62B8-FF82-4F73-8E86-7CD0C2147B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3280712"/>
              </p:ext>
            </p:extLst>
          </p:nvPr>
        </p:nvGraphicFramePr>
        <p:xfrm>
          <a:off x="142574" y="3805069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5D1FFC2E-F744-4072-A510-DED285D5CC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1894480"/>
              </p:ext>
            </p:extLst>
          </p:nvPr>
        </p:nvGraphicFramePr>
        <p:xfrm>
          <a:off x="4997201" y="3805069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92FC743A-7C14-4FE8-B11B-59EF1A25D6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5361740"/>
              </p:ext>
            </p:extLst>
          </p:nvPr>
        </p:nvGraphicFramePr>
        <p:xfrm>
          <a:off x="7460648" y="3805069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62F7D0EB-3727-4EE6-AF78-9FE4D4D004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1003178"/>
              </p:ext>
            </p:extLst>
          </p:nvPr>
        </p:nvGraphicFramePr>
        <p:xfrm>
          <a:off x="9918503" y="3805069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A0620061-377A-49E1-BDF9-F962FC822E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4374327"/>
              </p:ext>
            </p:extLst>
          </p:nvPr>
        </p:nvGraphicFramePr>
        <p:xfrm>
          <a:off x="123525" y="737715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8373F41F-C226-4202-8947-3348DF6C47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0817517"/>
              </p:ext>
            </p:extLst>
          </p:nvPr>
        </p:nvGraphicFramePr>
        <p:xfrm>
          <a:off x="5002792" y="728911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0D27291-6DC6-4261-810B-E5AFF067BCDC}"/>
              </a:ext>
            </a:extLst>
          </p:cNvPr>
          <p:cNvSpPr txBox="1"/>
          <p:nvPr/>
        </p:nvSpPr>
        <p:spPr>
          <a:xfrm>
            <a:off x="121393" y="70232"/>
            <a:ext cx="36747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-Figure 3-1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8D112EE-6C2D-47B3-8F32-529C93D279E8}"/>
              </a:ext>
            </a:extLst>
          </p:cNvPr>
          <p:cNvSpPr txBox="1"/>
          <p:nvPr/>
        </p:nvSpPr>
        <p:spPr>
          <a:xfrm>
            <a:off x="3751853" y="70232"/>
            <a:ext cx="605617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Cytokines which responded to </a:t>
            </a:r>
            <a:r>
              <a:rPr kumimoji="1" lang="en-US" altLang="ja-JP" sz="2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sA</a:t>
            </a:r>
            <a:r>
              <a:rPr kumimoji="1" lang="en-US" altLang="ja-JP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-1</a:t>
            </a:r>
            <a:endParaRPr kumimoji="1" lang="ja-JP" altLang="en-US" sz="2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EF85B28-A792-408F-B952-C5E421672371}"/>
              </a:ext>
            </a:extLst>
          </p:cNvPr>
          <p:cNvSpPr txBox="1"/>
          <p:nvPr/>
        </p:nvSpPr>
        <p:spPr>
          <a:xfrm>
            <a:off x="281725" y="992948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9DA58EC9-74E2-414E-A4F0-E0DBFE77BF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4830444"/>
              </p:ext>
            </p:extLst>
          </p:nvPr>
        </p:nvGraphicFramePr>
        <p:xfrm>
          <a:off x="7460648" y="738148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08907871-1936-47C8-8C6D-2332B42143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5063864"/>
              </p:ext>
            </p:extLst>
          </p:nvPr>
        </p:nvGraphicFramePr>
        <p:xfrm>
          <a:off x="2593295" y="737715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EA4A2E77-9CFF-4271-A6B3-3B8CB56388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8214059"/>
              </p:ext>
            </p:extLst>
          </p:nvPr>
        </p:nvGraphicFramePr>
        <p:xfrm>
          <a:off x="9918503" y="728911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5" name="グラフ 44">
            <a:extLst>
              <a:ext uri="{FF2B5EF4-FFF2-40B4-BE49-F238E27FC236}">
                <a16:creationId xmlns:a16="http://schemas.microsoft.com/office/drawing/2014/main" id="{3D6EEDCD-7929-412C-BDA0-C9D7373833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8100532"/>
              </p:ext>
            </p:extLst>
          </p:nvPr>
        </p:nvGraphicFramePr>
        <p:xfrm>
          <a:off x="2588938" y="3805069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3F05AED-6E54-4655-B89D-0B168953D7FE}"/>
              </a:ext>
            </a:extLst>
          </p:cNvPr>
          <p:cNvSpPr txBox="1"/>
          <p:nvPr/>
        </p:nvSpPr>
        <p:spPr>
          <a:xfrm>
            <a:off x="2710866" y="988391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771356F8-EE4C-40A8-8564-19AF3F214C6D}"/>
              </a:ext>
            </a:extLst>
          </p:cNvPr>
          <p:cNvSpPr txBox="1"/>
          <p:nvPr/>
        </p:nvSpPr>
        <p:spPr>
          <a:xfrm>
            <a:off x="5156064" y="988391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16CC5807-D357-4A8C-B183-883BEBE48671}"/>
              </a:ext>
            </a:extLst>
          </p:cNvPr>
          <p:cNvSpPr txBox="1"/>
          <p:nvPr/>
        </p:nvSpPr>
        <p:spPr>
          <a:xfrm>
            <a:off x="7618440" y="988391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C405D3D-0487-46D6-8A61-8480DB4C2010}"/>
              </a:ext>
            </a:extLst>
          </p:cNvPr>
          <p:cNvSpPr txBox="1"/>
          <p:nvPr/>
        </p:nvSpPr>
        <p:spPr>
          <a:xfrm>
            <a:off x="9990165" y="988391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6F23249D-A603-4DA3-A621-694E320DD7CA}"/>
              </a:ext>
            </a:extLst>
          </p:cNvPr>
          <p:cNvSpPr txBox="1"/>
          <p:nvPr/>
        </p:nvSpPr>
        <p:spPr>
          <a:xfrm>
            <a:off x="2710866" y="3983798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A4FBCF70-D986-43EE-AC12-B0D8FAFFAAA3}"/>
              </a:ext>
            </a:extLst>
          </p:cNvPr>
          <p:cNvSpPr txBox="1"/>
          <p:nvPr/>
        </p:nvSpPr>
        <p:spPr>
          <a:xfrm>
            <a:off x="5156064" y="3974273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BC617FB-6314-41C7-9670-EB2B3E3FCDD1}"/>
              </a:ext>
            </a:extLst>
          </p:cNvPr>
          <p:cNvSpPr txBox="1"/>
          <p:nvPr/>
        </p:nvSpPr>
        <p:spPr>
          <a:xfrm>
            <a:off x="10011858" y="3974273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49360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95F575FC-AD6B-4C62-8216-FBAAFBF427B1}"/>
              </a:ext>
            </a:extLst>
          </p:cNvPr>
          <p:cNvSpPr/>
          <p:nvPr/>
        </p:nvSpPr>
        <p:spPr>
          <a:xfrm>
            <a:off x="723114" y="1271014"/>
            <a:ext cx="126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BB67D269-AAAD-4C9F-AE64-D8AD19A9451D}"/>
              </a:ext>
            </a:extLst>
          </p:cNvPr>
          <p:cNvSpPr/>
          <p:nvPr/>
        </p:nvSpPr>
        <p:spPr>
          <a:xfrm>
            <a:off x="838925" y="1271014"/>
            <a:ext cx="3312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7D1E506C-AC22-4915-8A20-6C492913AA6E}"/>
              </a:ext>
            </a:extLst>
          </p:cNvPr>
          <p:cNvSpPr/>
          <p:nvPr/>
        </p:nvSpPr>
        <p:spPr>
          <a:xfrm>
            <a:off x="1170656" y="1271014"/>
            <a:ext cx="306000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07BCA50C-6C65-43D7-9884-1CF722CDCB30}"/>
              </a:ext>
            </a:extLst>
          </p:cNvPr>
          <p:cNvSpPr/>
          <p:nvPr/>
        </p:nvSpPr>
        <p:spPr>
          <a:xfrm>
            <a:off x="8157341" y="4369258"/>
            <a:ext cx="90000" cy="19872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421CA2CE-E2EA-4D40-8715-C84C232C8D38}"/>
              </a:ext>
            </a:extLst>
          </p:cNvPr>
          <p:cNvSpPr/>
          <p:nvPr/>
        </p:nvSpPr>
        <p:spPr>
          <a:xfrm>
            <a:off x="8245102" y="4369258"/>
            <a:ext cx="295200" cy="19872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C203B988-F8C1-41B3-BB07-502247A92D6D}"/>
              </a:ext>
            </a:extLst>
          </p:cNvPr>
          <p:cNvSpPr/>
          <p:nvPr/>
        </p:nvSpPr>
        <p:spPr>
          <a:xfrm>
            <a:off x="8540809" y="4369258"/>
            <a:ext cx="288000" cy="19872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A592F47C-7B17-47C7-A579-35E10FAC58BE}"/>
              </a:ext>
            </a:extLst>
          </p:cNvPr>
          <p:cNvSpPr/>
          <p:nvPr/>
        </p:nvSpPr>
        <p:spPr>
          <a:xfrm>
            <a:off x="723876" y="4367782"/>
            <a:ext cx="126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3F7656B8-CAF8-444E-AA35-DD2114A1FAD3}"/>
              </a:ext>
            </a:extLst>
          </p:cNvPr>
          <p:cNvSpPr/>
          <p:nvPr/>
        </p:nvSpPr>
        <p:spPr>
          <a:xfrm>
            <a:off x="839687" y="4367782"/>
            <a:ext cx="3096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AE557213-CCD8-4D7D-9149-EE025D15D10A}"/>
              </a:ext>
            </a:extLst>
          </p:cNvPr>
          <p:cNvSpPr/>
          <p:nvPr/>
        </p:nvSpPr>
        <p:spPr>
          <a:xfrm>
            <a:off x="1151606" y="4367782"/>
            <a:ext cx="298800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E892C9AE-7BD3-4599-A0CC-D97221C33DC2}"/>
              </a:ext>
            </a:extLst>
          </p:cNvPr>
          <p:cNvSpPr/>
          <p:nvPr/>
        </p:nvSpPr>
        <p:spPr>
          <a:xfrm>
            <a:off x="3170396" y="4358638"/>
            <a:ext cx="126000" cy="19872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89E3FF22-6CB3-4B2A-85A9-3B220ACEE4E6}"/>
              </a:ext>
            </a:extLst>
          </p:cNvPr>
          <p:cNvSpPr/>
          <p:nvPr/>
        </p:nvSpPr>
        <p:spPr>
          <a:xfrm>
            <a:off x="3286207" y="4358638"/>
            <a:ext cx="309600" cy="19872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3982AA22-1960-4024-B357-26B73ADB2AA7}"/>
              </a:ext>
            </a:extLst>
          </p:cNvPr>
          <p:cNvSpPr/>
          <p:nvPr/>
        </p:nvSpPr>
        <p:spPr>
          <a:xfrm>
            <a:off x="3598126" y="4358638"/>
            <a:ext cx="298800" cy="19872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B72557E3-34C5-40B0-8C3F-CED9DCDEFE25}"/>
              </a:ext>
            </a:extLst>
          </p:cNvPr>
          <p:cNvSpPr/>
          <p:nvPr/>
        </p:nvSpPr>
        <p:spPr>
          <a:xfrm>
            <a:off x="5703824" y="4367782"/>
            <a:ext cx="126000" cy="19872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00D0C1AC-35A7-4EC7-AABE-5E9F91FB6F3D}"/>
              </a:ext>
            </a:extLst>
          </p:cNvPr>
          <p:cNvSpPr/>
          <p:nvPr/>
        </p:nvSpPr>
        <p:spPr>
          <a:xfrm>
            <a:off x="5819635" y="4367782"/>
            <a:ext cx="288000" cy="19872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33093D48-D737-4725-9DB8-186773BD07FA}"/>
              </a:ext>
            </a:extLst>
          </p:cNvPr>
          <p:cNvSpPr/>
          <p:nvPr/>
        </p:nvSpPr>
        <p:spPr>
          <a:xfrm>
            <a:off x="6104122" y="4367782"/>
            <a:ext cx="298800" cy="19872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4298FB31-7349-4835-8140-E833222C23AA}"/>
              </a:ext>
            </a:extLst>
          </p:cNvPr>
          <p:cNvSpPr/>
          <p:nvPr/>
        </p:nvSpPr>
        <p:spPr>
          <a:xfrm>
            <a:off x="3190067" y="1271014"/>
            <a:ext cx="126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2CAB1D88-44C6-4FD6-99C3-4E123239F717}"/>
              </a:ext>
            </a:extLst>
          </p:cNvPr>
          <p:cNvSpPr/>
          <p:nvPr/>
        </p:nvSpPr>
        <p:spPr>
          <a:xfrm>
            <a:off x="3305878" y="1271014"/>
            <a:ext cx="2880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20F0203A-4858-490F-949F-C3A514751780}"/>
              </a:ext>
            </a:extLst>
          </p:cNvPr>
          <p:cNvSpPr/>
          <p:nvPr/>
        </p:nvSpPr>
        <p:spPr>
          <a:xfrm>
            <a:off x="3593899" y="1271014"/>
            <a:ext cx="298800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1696B845-226E-4EA2-8677-4A3C94965E82}"/>
              </a:ext>
            </a:extLst>
          </p:cNvPr>
          <p:cNvSpPr/>
          <p:nvPr/>
        </p:nvSpPr>
        <p:spPr>
          <a:xfrm>
            <a:off x="5656672" y="1271014"/>
            <a:ext cx="108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1ADBF2AA-326B-4356-8583-07A49FB8F83D}"/>
              </a:ext>
            </a:extLst>
          </p:cNvPr>
          <p:cNvSpPr/>
          <p:nvPr/>
        </p:nvSpPr>
        <p:spPr>
          <a:xfrm>
            <a:off x="5762957" y="1271014"/>
            <a:ext cx="2952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C23E813A-7D28-4592-B144-F9F8AA01839C}"/>
              </a:ext>
            </a:extLst>
          </p:cNvPr>
          <p:cNvSpPr/>
          <p:nvPr/>
        </p:nvSpPr>
        <p:spPr>
          <a:xfrm>
            <a:off x="6056588" y="1271014"/>
            <a:ext cx="298800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D79A46EA-E5C5-49D7-85BA-43CBE6D91343}"/>
              </a:ext>
            </a:extLst>
          </p:cNvPr>
          <p:cNvSpPr/>
          <p:nvPr/>
        </p:nvSpPr>
        <p:spPr>
          <a:xfrm>
            <a:off x="8189952" y="1271014"/>
            <a:ext cx="126000" cy="1980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0315FF10-DA8A-4DD7-B89C-11E5E57DADCB}"/>
              </a:ext>
            </a:extLst>
          </p:cNvPr>
          <p:cNvSpPr/>
          <p:nvPr/>
        </p:nvSpPr>
        <p:spPr>
          <a:xfrm>
            <a:off x="8305763" y="1271014"/>
            <a:ext cx="295200" cy="1980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CD1295C6-9359-44DA-A707-5A556787625B}"/>
              </a:ext>
            </a:extLst>
          </p:cNvPr>
          <p:cNvSpPr/>
          <p:nvPr/>
        </p:nvSpPr>
        <p:spPr>
          <a:xfrm>
            <a:off x="8599394" y="1271014"/>
            <a:ext cx="298800" cy="1980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7CB2BAAE-BA3D-4CD1-A76B-09E5BE9D5A23}"/>
              </a:ext>
            </a:extLst>
          </p:cNvPr>
          <p:cNvSpPr/>
          <p:nvPr/>
        </p:nvSpPr>
        <p:spPr>
          <a:xfrm>
            <a:off x="10524417" y="1280540"/>
            <a:ext cx="108000" cy="1962000"/>
          </a:xfrm>
          <a:prstGeom prst="rect">
            <a:avLst/>
          </a:prstGeom>
          <a:solidFill>
            <a:schemeClr val="bg1">
              <a:lumMod val="5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652B4723-9348-40A9-8AD0-FC1AE9BE6580}"/>
              </a:ext>
            </a:extLst>
          </p:cNvPr>
          <p:cNvSpPr/>
          <p:nvPr/>
        </p:nvSpPr>
        <p:spPr>
          <a:xfrm>
            <a:off x="10625557" y="1280540"/>
            <a:ext cx="324000" cy="1962000"/>
          </a:xfrm>
          <a:prstGeom prst="rect">
            <a:avLst/>
          </a:prstGeom>
          <a:solidFill>
            <a:schemeClr val="bg1">
              <a:lumMod val="75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32D3E779-837C-4B28-B94C-BEE1BE6ACFD8}"/>
              </a:ext>
            </a:extLst>
          </p:cNvPr>
          <p:cNvSpPr/>
          <p:nvPr/>
        </p:nvSpPr>
        <p:spPr>
          <a:xfrm>
            <a:off x="10946620" y="1280540"/>
            <a:ext cx="298800" cy="1962000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FB4DB27A-8C4E-4573-8108-D43ADEF9F1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2636348"/>
              </p:ext>
            </p:extLst>
          </p:nvPr>
        </p:nvGraphicFramePr>
        <p:xfrm>
          <a:off x="5024616" y="735456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513FC5C6-64FE-4C0B-AB4D-500850CA63A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9444996"/>
              </p:ext>
            </p:extLst>
          </p:nvPr>
        </p:nvGraphicFramePr>
        <p:xfrm>
          <a:off x="5018088" y="3822552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CA76A8B3-6C92-4C41-BBC5-FE5FAAA69C2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6194927"/>
              </p:ext>
            </p:extLst>
          </p:nvPr>
        </p:nvGraphicFramePr>
        <p:xfrm>
          <a:off x="2578075" y="735456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588A44E-24BC-49DB-B1B5-43C202C153D0}"/>
              </a:ext>
            </a:extLst>
          </p:cNvPr>
          <p:cNvSpPr txBox="1"/>
          <p:nvPr/>
        </p:nvSpPr>
        <p:spPr>
          <a:xfrm>
            <a:off x="0" y="85645"/>
            <a:ext cx="37130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-Figure 3-2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CBC7CF3-EE0C-4F35-AD1B-EAD4C482CB91}"/>
              </a:ext>
            </a:extLst>
          </p:cNvPr>
          <p:cNvSpPr txBox="1"/>
          <p:nvPr/>
        </p:nvSpPr>
        <p:spPr>
          <a:xfrm>
            <a:off x="3565470" y="85645"/>
            <a:ext cx="788690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3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cytokines which responded to </a:t>
            </a:r>
            <a:r>
              <a:rPr kumimoji="1" lang="en-US" altLang="ja-JP" sz="3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sA</a:t>
            </a:r>
            <a:r>
              <a:rPr kumimoji="1" lang="en-US" altLang="ja-JP" sz="3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-2</a:t>
            </a:r>
          </a:p>
        </p:txBody>
      </p:sp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F09A982F-4709-4E9F-A5E1-9A56343BFB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6250114"/>
              </p:ext>
            </p:extLst>
          </p:nvPr>
        </p:nvGraphicFramePr>
        <p:xfrm>
          <a:off x="125833" y="3822552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4FE34A08-98A1-41B6-BA66-86CBA135105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0142252"/>
              </p:ext>
            </p:extLst>
          </p:nvPr>
        </p:nvGraphicFramePr>
        <p:xfrm>
          <a:off x="2574925" y="3822552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4" name="グラフ 33">
            <a:extLst>
              <a:ext uri="{FF2B5EF4-FFF2-40B4-BE49-F238E27FC236}">
                <a16:creationId xmlns:a16="http://schemas.microsoft.com/office/drawing/2014/main" id="{4074508D-1714-4F81-97D8-5769523A2C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0139636"/>
              </p:ext>
            </p:extLst>
          </p:nvPr>
        </p:nvGraphicFramePr>
        <p:xfrm>
          <a:off x="7471157" y="735456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AA072E90-F47B-4215-BA30-F3B0721DFC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3508996"/>
              </p:ext>
            </p:extLst>
          </p:nvPr>
        </p:nvGraphicFramePr>
        <p:xfrm>
          <a:off x="9917700" y="735456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793D050-2C4A-48AA-8E24-6A5D15E93D9D}"/>
              </a:ext>
            </a:extLst>
          </p:cNvPr>
          <p:cNvSpPr txBox="1"/>
          <p:nvPr/>
        </p:nvSpPr>
        <p:spPr>
          <a:xfrm>
            <a:off x="7777138" y="1016000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012AAEB-B7B7-4CF2-92CA-83C3FCAFC3EF}"/>
              </a:ext>
            </a:extLst>
          </p:cNvPr>
          <p:cNvSpPr txBox="1"/>
          <p:nvPr/>
        </p:nvSpPr>
        <p:spPr>
          <a:xfrm>
            <a:off x="10067710" y="1016000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F0D7E7A0-6809-4957-985E-9C3474DD2D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1347774"/>
              </p:ext>
            </p:extLst>
          </p:nvPr>
        </p:nvGraphicFramePr>
        <p:xfrm>
          <a:off x="131534" y="728388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0407FE6-6EC9-4036-A79F-8342B173DAA9}"/>
              </a:ext>
            </a:extLst>
          </p:cNvPr>
          <p:cNvSpPr txBox="1"/>
          <p:nvPr/>
        </p:nvSpPr>
        <p:spPr>
          <a:xfrm>
            <a:off x="220220" y="1033463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3B238CA7-112E-4BEC-8FCD-E38D16152D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8816419"/>
              </p:ext>
            </p:extLst>
          </p:nvPr>
        </p:nvGraphicFramePr>
        <p:xfrm>
          <a:off x="7464425" y="3822552"/>
          <a:ext cx="216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EEF4B13-BFA5-4067-91A5-970C3F6B11F6}"/>
              </a:ext>
            </a:extLst>
          </p:cNvPr>
          <p:cNvSpPr txBox="1"/>
          <p:nvPr/>
        </p:nvSpPr>
        <p:spPr>
          <a:xfrm>
            <a:off x="7697509" y="4127806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g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mL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0598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37</TotalTime>
  <Words>106</Words>
  <Application>Microsoft Office PowerPoint</Application>
  <PresentationFormat>ワイド画面</PresentationFormat>
  <Paragraphs>50</Paragraphs>
  <Slides>4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 b</dc:creator>
  <cp:lastModifiedBy>a b</cp:lastModifiedBy>
  <cp:revision>58</cp:revision>
  <cp:lastPrinted>2022-02-25T11:44:42Z</cp:lastPrinted>
  <dcterms:created xsi:type="dcterms:W3CDTF">2022-01-28T02:27:55Z</dcterms:created>
  <dcterms:modified xsi:type="dcterms:W3CDTF">2022-03-06T11:58:15Z</dcterms:modified>
</cp:coreProperties>
</file>